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3569" autoAdjust="0"/>
    <p:restoredTop sz="94660"/>
  </p:normalViewPr>
  <p:slideViewPr>
    <p:cSldViewPr snapToGrid="0">
      <p:cViewPr>
        <p:scale>
          <a:sx n="56" d="100"/>
          <a:sy n="56" d="100"/>
        </p:scale>
        <p:origin x="356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B16EF2B-46FF-4700-AC9F-224F96BDC4B4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2C7B365-4E25-400A-B1EA-9041C1EEFBD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314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CDB995-28A8-AD15-4BF8-44DEA7A46D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5D6A22-169F-DC07-0D82-7552BBF7A9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0475B2-9F70-AAA3-9A9B-70E4748AE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8D072D-DF56-ED5E-1D1D-D78D10D757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963E4E-5925-ACD9-BE9A-74FF97ED6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906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8F403D-280E-F5A8-C36D-44DC038DF1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84F2F22-89BA-EFDA-4292-ECC3A37902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F378C0-E1F5-DC0F-6228-AA96F2A19F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3F0FEC-0E04-3772-3053-5C177C5A27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5D28D8-7086-0AB1-1FED-36AECFAF95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423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750A5C2-D804-57CD-5BA6-14C2A9D82B6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716D31-CC75-361F-0718-7AB34D260F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A9D8B9-31B2-80D7-B39D-13450AA008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79F23C-71F4-1E3E-BC5F-4FD27882AE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1CF2F5C-F675-D53A-4C61-23DAD54766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612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EE245-7BBB-F5BB-A81B-A1794A6DA4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A85641C-5BD0-E367-E8F5-CB3A1C98587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3B51B0-C0A8-A9D2-4CA5-C2021A18B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277B09-CF90-39A0-9A74-C1F8C62C9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4972D6-79A2-3E20-6354-45B2B4F40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900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E30B4E-971A-E20D-57AD-4ABEB17A5B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FA73F7-7C8C-E682-90D1-A159A2307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3C02F5-FFD2-BB18-5741-43B46CC84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882AF0-C655-FCFB-F15D-FFB6942644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ADDD40-67D9-D744-F5CB-6F26D4029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890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CD361-184D-98B9-B8E7-95A8819C1F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F96A12-76DD-1D56-D7A5-CCD994A2CF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C13614C-D6C2-3040-E34D-DD1FC9C65AF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8FD82DB-9855-06D5-CC4C-B75A14EA9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F4CEFC-4EB8-D65C-1400-9E0966C78B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A30ED0-70DE-5B32-54C1-E17C1D0707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292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048A62-2A05-2471-AAD4-D8A842939A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0F5904-BFF3-DBE9-24ED-266206747F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82F59C-5E8A-3F64-BEBC-39C7D048606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C05CEF-7A9F-B88D-4DD7-0EAC922899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5CD9523-D616-635A-5B5F-792B0DFE3B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EDA4AB-080B-B213-BAF5-6CB0A310E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F41646-9896-E04A-254B-1CBD56CE07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73A116-93D9-0D15-AA55-499FF4BC09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3377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49CE87-5851-C044-DAC7-E0B697AC6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84462D4-8447-EE43-6AC7-50E6AA7E2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92EB08A-5466-FE92-5663-4F0D42237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FA36FA-AF7B-F018-2FFE-8C1CC95045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505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D23DF07-D5E4-146B-9475-B6B42E75C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EB42A7-24CB-B6F2-A823-F406F97310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0BA6024-7732-80B4-F3B4-EAA2F9051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825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3617B-DE7D-D262-1C90-A56EE2746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2510352-B8CA-1E96-83C7-E71FF2BA8B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1BABD5-008E-163A-DD1F-5CBF5B7ADC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116999-84AC-DB99-535E-50C882AEC7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33DECED-30E7-AC25-1299-6062A33F3B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22ABA08-1194-1336-FEA0-F73E9206B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264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A3E1B1-F24C-FA06-8FF1-3B1276A824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A06ED14-5794-6E84-86BC-06B4DA6ED0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4254B0A-E806-4BDD-326A-1E1A84D4E50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5F5A3E-FD30-BD06-31F6-DA6FDA7DC2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F23B24-1FCA-6650-3E49-6B3B320FF2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741797-650E-21EA-3A39-C4E6016C9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872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67102F5-F2CD-F6D5-08A1-88D2166083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E44BCD-A83D-67B1-7677-DB4C261339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4A6531-A144-89D8-5126-74CFEB4178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096A9A-3BA3-4594-BBAD-90A09FAF0323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C495C8-9420-8431-55F3-D4C4BD781BD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BE4852-5716-DB70-C26D-A72906C93F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F92E654-E4AB-47A7-ABD7-FD4BC74754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776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jpg"/><Relationship Id="rId13" Type="http://schemas.microsoft.com/office/2007/relationships/hdphoto" Target="../media/hdphoto4.wdp"/><Relationship Id="rId3" Type="http://schemas.openxmlformats.org/officeDocument/2006/relationships/image" Target="../media/image2.jpg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microsoft.com/office/2007/relationships/hdphoto" Target="../media/hdphoto3.wdp"/><Relationship Id="rId5" Type="http://schemas.microsoft.com/office/2007/relationships/hdphoto" Target="../media/hdphoto1.wdp"/><Relationship Id="rId10" Type="http://schemas.openxmlformats.org/officeDocument/2006/relationships/image" Target="../media/image7.png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jpg"/><Relationship Id="rId13" Type="http://schemas.microsoft.com/office/2007/relationships/hdphoto" Target="../media/hdphoto8.wdp"/><Relationship Id="rId3" Type="http://schemas.openxmlformats.org/officeDocument/2006/relationships/image" Target="../media/image10.png"/><Relationship Id="rId7" Type="http://schemas.microsoft.com/office/2007/relationships/hdphoto" Target="../media/hdphoto6.wdp"/><Relationship Id="rId12" Type="http://schemas.openxmlformats.org/officeDocument/2006/relationships/image" Target="../media/image16.pn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11" Type="http://schemas.microsoft.com/office/2007/relationships/hdphoto" Target="../media/hdphoto7.wdp"/><Relationship Id="rId5" Type="http://schemas.openxmlformats.org/officeDocument/2006/relationships/image" Target="../media/image11.jpg"/><Relationship Id="rId10" Type="http://schemas.openxmlformats.org/officeDocument/2006/relationships/image" Target="../media/image15.png"/><Relationship Id="rId4" Type="http://schemas.microsoft.com/office/2007/relationships/hdphoto" Target="../media/hdphoto5.wdp"/><Relationship Id="rId9" Type="http://schemas.openxmlformats.org/officeDocument/2006/relationships/image" Target="../media/image14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g"/><Relationship Id="rId3" Type="http://schemas.openxmlformats.org/officeDocument/2006/relationships/image" Target="../media/image18.jpg"/><Relationship Id="rId7" Type="http://schemas.openxmlformats.org/officeDocument/2006/relationships/image" Target="../media/image22.jp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10" Type="http://schemas.openxmlformats.org/officeDocument/2006/relationships/image" Target="../media/image25.jpg"/><Relationship Id="rId4" Type="http://schemas.openxmlformats.org/officeDocument/2006/relationships/image" Target="../media/image19.jpg"/><Relationship Id="rId9" Type="http://schemas.openxmlformats.org/officeDocument/2006/relationships/image" Target="../media/image24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>
            <a:extLst>
              <a:ext uri="{FF2B5EF4-FFF2-40B4-BE49-F238E27FC236}">
                <a16:creationId xmlns:a16="http://schemas.microsoft.com/office/drawing/2014/main" id="{1E5D5AC9-AD1F-F540-B44F-D973910BD4D1}"/>
              </a:ext>
            </a:extLst>
          </p:cNvPr>
          <p:cNvSpPr txBox="1"/>
          <p:nvPr/>
        </p:nvSpPr>
        <p:spPr>
          <a:xfrm>
            <a:off x="91398" y="34133"/>
            <a:ext cx="225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Figure 4</a:t>
            </a:r>
          </a:p>
        </p:txBody>
      </p:sp>
      <p:grpSp>
        <p:nvGrpSpPr>
          <p:cNvPr id="62" name="Group 61">
            <a:extLst>
              <a:ext uri="{FF2B5EF4-FFF2-40B4-BE49-F238E27FC236}">
                <a16:creationId xmlns:a16="http://schemas.microsoft.com/office/drawing/2014/main" id="{17B2F7F2-17F9-2AFD-E0C7-97863C48903D}"/>
              </a:ext>
            </a:extLst>
          </p:cNvPr>
          <p:cNvGrpSpPr/>
          <p:nvPr/>
        </p:nvGrpSpPr>
        <p:grpSpPr>
          <a:xfrm>
            <a:off x="230916" y="315250"/>
            <a:ext cx="5846400" cy="6323577"/>
            <a:chOff x="230916" y="372400"/>
            <a:chExt cx="5846400" cy="6323577"/>
          </a:xfrm>
        </p:grpSpPr>
        <p:pic>
          <p:nvPicPr>
            <p:cNvPr id="18" name="Picture 17" descr="A close-up of a test tube&#10;&#10;Description automatically generated">
              <a:extLst>
                <a:ext uri="{FF2B5EF4-FFF2-40B4-BE49-F238E27FC236}">
                  <a16:creationId xmlns:a16="http://schemas.microsoft.com/office/drawing/2014/main" id="{59ABE926-F792-3B4D-A9BF-8B8FDA3078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7009" b="39301"/>
            <a:stretch/>
          </p:blipFill>
          <p:spPr>
            <a:xfrm>
              <a:off x="715685" y="2164851"/>
              <a:ext cx="4284533" cy="1462156"/>
            </a:xfrm>
            <a:prstGeom prst="rect">
              <a:avLst/>
            </a:prstGeom>
          </p:spPr>
        </p:pic>
        <p:pic>
          <p:nvPicPr>
            <p:cNvPr id="19" name="Picture 18" descr="A close-up of a test tube&#10;&#10;Description automatically generated">
              <a:extLst>
                <a:ext uri="{FF2B5EF4-FFF2-40B4-BE49-F238E27FC236}">
                  <a16:creationId xmlns:a16="http://schemas.microsoft.com/office/drawing/2014/main" id="{CF08FB73-3FC8-BF3D-A172-F89348CCA5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979" b="33625"/>
            <a:stretch/>
          </p:blipFill>
          <p:spPr>
            <a:xfrm>
              <a:off x="726981" y="4676425"/>
              <a:ext cx="4284532" cy="1185122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BA28D1D-4E4F-1CB1-BB81-44713DC4CA16}"/>
                </a:ext>
              </a:extLst>
            </p:cNvPr>
            <p:cNvSpPr txBox="1"/>
            <p:nvPr/>
          </p:nvSpPr>
          <p:spPr>
            <a:xfrm rot="16200000">
              <a:off x="-124792" y="5341777"/>
              <a:ext cx="1185121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RMT11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07170D47-D17A-1ECA-275D-EECC0847DA6B}"/>
                </a:ext>
              </a:extLst>
            </p:cNvPr>
            <p:cNvSpPr txBox="1"/>
            <p:nvPr/>
          </p:nvSpPr>
          <p:spPr>
            <a:xfrm rot="16200000">
              <a:off x="-9827" y="2985468"/>
              <a:ext cx="955188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dirty="0">
                  <a:latin typeface="Aptos" panose="020B0004020202020204" pitchFamily="34" charset="0"/>
                </a:rPr>
                <a:t>β</a:t>
              </a:r>
              <a:r>
                <a:rPr lang="en-US" dirty="0">
                  <a:latin typeface="Aptos" panose="020B0004020202020204" pitchFamily="34" charset="0"/>
                </a:rPr>
                <a:t>-</a:t>
              </a:r>
              <a:r>
                <a:rPr lang="en-US" dirty="0"/>
                <a:t>Actin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18116B8E-F080-E986-BA3A-2CAF3F6FBBC0}"/>
                </a:ext>
              </a:extLst>
            </p:cNvPr>
            <p:cNvSpPr txBox="1"/>
            <p:nvPr/>
          </p:nvSpPr>
          <p:spPr>
            <a:xfrm rot="17931823">
              <a:off x="1079876" y="1497794"/>
              <a:ext cx="831129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MEC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7F9D46E-37DD-F8EB-8B0F-3DA843255CD4}"/>
                </a:ext>
              </a:extLst>
            </p:cNvPr>
            <p:cNvSpPr txBox="1"/>
            <p:nvPr/>
          </p:nvSpPr>
          <p:spPr>
            <a:xfrm rot="17931823">
              <a:off x="1491298" y="1565998"/>
              <a:ext cx="805994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HMLE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61E1954-7783-3D0D-B4E2-F7964CEAABAF}"/>
                </a:ext>
              </a:extLst>
            </p:cNvPr>
            <p:cNvSpPr txBox="1"/>
            <p:nvPr/>
          </p:nvSpPr>
          <p:spPr>
            <a:xfrm rot="17931823">
              <a:off x="1816534" y="1444529"/>
              <a:ext cx="122876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ZR- 7530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3A3370E-E555-0845-05E3-FE42E9A246B4}"/>
                </a:ext>
              </a:extLst>
            </p:cNvPr>
            <p:cNvSpPr txBox="1"/>
            <p:nvPr/>
          </p:nvSpPr>
          <p:spPr>
            <a:xfrm rot="17931823">
              <a:off x="2342463" y="1569735"/>
              <a:ext cx="105696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T-474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4CAA1FF-F3DD-FCC1-8A79-75D77E1CF9EE}"/>
                </a:ext>
              </a:extLst>
            </p:cNvPr>
            <p:cNvSpPr txBox="1"/>
            <p:nvPr/>
          </p:nvSpPr>
          <p:spPr>
            <a:xfrm rot="17931823">
              <a:off x="2868138" y="1549602"/>
              <a:ext cx="851630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KBR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178CFDB2-182F-BC6D-90BF-3203F78C2B01}"/>
                </a:ext>
              </a:extLst>
            </p:cNvPr>
            <p:cNvSpPr txBox="1"/>
            <p:nvPr/>
          </p:nvSpPr>
          <p:spPr>
            <a:xfrm rot="17931823">
              <a:off x="2984577" y="1122902"/>
              <a:ext cx="1829932" cy="4737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DA-MB-231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FC2833B-0F69-3B45-0E6D-06FD7288B3E5}"/>
                </a:ext>
              </a:extLst>
            </p:cNvPr>
            <p:cNvSpPr txBox="1"/>
            <p:nvPr/>
          </p:nvSpPr>
          <p:spPr>
            <a:xfrm rot="17931823">
              <a:off x="3582819" y="1388245"/>
              <a:ext cx="1207939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UM1315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0E0AA982-C36C-5127-A534-0C778FB077CB}"/>
                </a:ext>
              </a:extLst>
            </p:cNvPr>
            <p:cNvSpPr txBox="1"/>
            <p:nvPr/>
          </p:nvSpPr>
          <p:spPr>
            <a:xfrm rot="17931823">
              <a:off x="4042357" y="1407297"/>
              <a:ext cx="1079807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UM149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04A04D03-80E1-E65C-8F04-3DF1CE70B2E1}"/>
                </a:ext>
              </a:extLst>
            </p:cNvPr>
            <p:cNvSpPr txBox="1"/>
            <p:nvPr/>
          </p:nvSpPr>
          <p:spPr>
            <a:xfrm rot="17931823">
              <a:off x="4432369" y="1444353"/>
              <a:ext cx="1079807" cy="4737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UM159</a:t>
              </a:r>
            </a:p>
          </p:txBody>
        </p: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DE39C383-B961-C67B-0E6F-C57962F236E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439215" y="787074"/>
              <a:ext cx="160944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01A556B9-4061-E16B-C517-B4BCA36377BB}"/>
                </a:ext>
              </a:extLst>
            </p:cNvPr>
            <p:cNvSpPr txBox="1"/>
            <p:nvPr/>
          </p:nvSpPr>
          <p:spPr>
            <a:xfrm flipH="1">
              <a:off x="3799308" y="374309"/>
              <a:ext cx="1024719" cy="404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TNBC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03306246-8961-BBE0-CD0B-2C722A000B2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40707" y="787074"/>
              <a:ext cx="1154048" cy="0"/>
            </a:xfrm>
            <a:prstGeom prst="line">
              <a:avLst/>
            </a:prstGeom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0C742195-E18D-D2E3-3648-1B1E459900FA}"/>
                </a:ext>
              </a:extLst>
            </p:cNvPr>
            <p:cNvSpPr txBox="1"/>
            <p:nvPr/>
          </p:nvSpPr>
          <p:spPr>
            <a:xfrm flipH="1">
              <a:off x="2395403" y="372400"/>
              <a:ext cx="1247823" cy="40440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HR +</a:t>
              </a:r>
              <a:r>
                <a:rPr lang="en-US" b="1" dirty="0" err="1"/>
                <a:t>ve</a:t>
              </a:r>
              <a:endParaRPr lang="en-US" b="1" dirty="0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A5790E1-59E0-C6F5-7990-7B3C53F7A508}"/>
                </a:ext>
              </a:extLst>
            </p:cNvPr>
            <p:cNvSpPr txBox="1"/>
            <p:nvPr/>
          </p:nvSpPr>
          <p:spPr>
            <a:xfrm flipH="1">
              <a:off x="756694" y="458457"/>
              <a:ext cx="165372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Non-tumorigenic </a:t>
              </a:r>
            </a:p>
          </p:txBody>
        </p: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DF300A32-8C1F-49A5-844B-510A49EC66F4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028423" y="787074"/>
              <a:ext cx="1154048" cy="0"/>
            </a:xfrm>
            <a:prstGeom prst="line">
              <a:avLst/>
            </a:prstGeom>
            <a:ln>
              <a:solidFill>
                <a:schemeClr val="accent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43BE7E2A-A08C-7441-E707-BA041F33A1D8}"/>
                </a:ext>
              </a:extLst>
            </p:cNvPr>
            <p:cNvCxnSpPr>
              <a:cxnSpLocks/>
            </p:cNvCxnSpPr>
            <p:nvPr/>
          </p:nvCxnSpPr>
          <p:spPr>
            <a:xfrm>
              <a:off x="5009807" y="5262052"/>
              <a:ext cx="17592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653FF250-E6FF-F12C-95BC-D7BD8675AFCB}"/>
                </a:ext>
              </a:extLst>
            </p:cNvPr>
            <p:cNvSpPr txBox="1"/>
            <p:nvPr/>
          </p:nvSpPr>
          <p:spPr>
            <a:xfrm>
              <a:off x="5182547" y="5117436"/>
              <a:ext cx="894769" cy="3370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4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F2F70697-EDDA-E490-8E78-CBB46703ADCF}"/>
                </a:ext>
              </a:extLst>
            </p:cNvPr>
            <p:cNvCxnSpPr>
              <a:cxnSpLocks/>
            </p:cNvCxnSpPr>
            <p:nvPr/>
          </p:nvCxnSpPr>
          <p:spPr>
            <a:xfrm>
              <a:off x="4979925" y="3034264"/>
              <a:ext cx="17592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D92C88A-4353-C3C7-8DC2-955CECC6C62F}"/>
                </a:ext>
              </a:extLst>
            </p:cNvPr>
            <p:cNvSpPr txBox="1"/>
            <p:nvPr/>
          </p:nvSpPr>
          <p:spPr>
            <a:xfrm>
              <a:off x="5097269" y="2855431"/>
              <a:ext cx="943867" cy="33700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42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pic>
          <p:nvPicPr>
            <p:cNvPr id="56" name="Picture 55" descr="A close-up of a black line&#10;&#10;Description automatically generated">
              <a:extLst>
                <a:ext uri="{FF2B5EF4-FFF2-40B4-BE49-F238E27FC236}">
                  <a16:creationId xmlns:a16="http://schemas.microsoft.com/office/drawing/2014/main" id="{BC0A63B0-2727-A50F-BD2F-AF904B3133A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46" t="45163" b="40097"/>
            <a:stretch/>
          </p:blipFill>
          <p:spPr>
            <a:xfrm>
              <a:off x="1162168" y="5924365"/>
              <a:ext cx="3838049" cy="77161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7" name="Picture 56" descr="A black lines on a white background&#10;&#10;Description automatically generated">
              <a:extLst>
                <a:ext uri="{FF2B5EF4-FFF2-40B4-BE49-F238E27FC236}">
                  <a16:creationId xmlns:a16="http://schemas.microsoft.com/office/drawing/2014/main" id="{AA1C26E6-19FA-E7BF-0EA6-D54A05F6CF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900" t="45036" r="1252" b="39929"/>
            <a:stretch/>
          </p:blipFill>
          <p:spPr>
            <a:xfrm>
              <a:off x="1029293" y="3675202"/>
              <a:ext cx="3940589" cy="81745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358481F6-6344-A583-4CEA-697403D07033}"/>
                </a:ext>
              </a:extLst>
            </p:cNvPr>
            <p:cNvSpPr txBox="1"/>
            <p:nvPr/>
          </p:nvSpPr>
          <p:spPr>
            <a:xfrm>
              <a:off x="4996135" y="3176522"/>
              <a:ext cx="516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JPEG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6D6CB5F9-3C28-8CDC-BA0C-E1D33BD9B119}"/>
                </a:ext>
              </a:extLst>
            </p:cNvPr>
            <p:cNvSpPr txBox="1"/>
            <p:nvPr/>
          </p:nvSpPr>
          <p:spPr>
            <a:xfrm>
              <a:off x="4979925" y="3923593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TIF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B589A6EF-3E10-41F1-6469-2FCF3DCA928E}"/>
                </a:ext>
              </a:extLst>
            </p:cNvPr>
            <p:cNvSpPr txBox="1"/>
            <p:nvPr/>
          </p:nvSpPr>
          <p:spPr>
            <a:xfrm>
              <a:off x="5050085" y="5414658"/>
              <a:ext cx="5166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JPEG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9BA5628-FC03-B13C-FFCF-B799ACF893A3}"/>
                </a:ext>
              </a:extLst>
            </p:cNvPr>
            <p:cNvSpPr txBox="1"/>
            <p:nvPr/>
          </p:nvSpPr>
          <p:spPr>
            <a:xfrm>
              <a:off x="5033875" y="6161729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TIF</a:t>
              </a: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70FB5035-CE09-5C4D-929A-D954C28D4ACD}"/>
              </a:ext>
            </a:extLst>
          </p:cNvPr>
          <p:cNvGrpSpPr/>
          <p:nvPr/>
        </p:nvGrpSpPr>
        <p:grpSpPr>
          <a:xfrm>
            <a:off x="6947701" y="858950"/>
            <a:ext cx="4917151" cy="5765915"/>
            <a:chOff x="6947701" y="858950"/>
            <a:chExt cx="4917151" cy="5765915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EB49788B-DDFF-DEDC-1049-01C0C17550CE}"/>
                </a:ext>
              </a:extLst>
            </p:cNvPr>
            <p:cNvGrpSpPr/>
            <p:nvPr/>
          </p:nvGrpSpPr>
          <p:grpSpPr>
            <a:xfrm>
              <a:off x="6947701" y="858950"/>
              <a:ext cx="4917151" cy="5681925"/>
              <a:chOff x="7094581" y="240600"/>
              <a:chExt cx="4421256" cy="5153544"/>
            </a:xfrm>
          </p:grpSpPr>
          <p:pic>
            <p:nvPicPr>
              <p:cNvPr id="2" name="Picture 1" descr="A close-up of a white plastic&#10;&#10;Description automatically generated">
                <a:extLst>
                  <a:ext uri="{FF2B5EF4-FFF2-40B4-BE49-F238E27FC236}">
                    <a16:creationId xmlns:a16="http://schemas.microsoft.com/office/drawing/2014/main" id="{30E91625-0BDF-45C4-72C9-87A02574A5A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6861" r="17168" b="37072"/>
              <a:stretch/>
            </p:blipFill>
            <p:spPr>
              <a:xfrm>
                <a:off x="7486424" y="3699913"/>
                <a:ext cx="3216831" cy="1068815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F228D362-5C4E-A6E5-F5EB-FD3921DB6D8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8347" t="30965" r="15209" b="21815"/>
              <a:stretch/>
            </p:blipFill>
            <p:spPr>
              <a:xfrm>
                <a:off x="7463912" y="1356003"/>
                <a:ext cx="3216831" cy="1462157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8E62F3F-3EB9-2C11-6563-83DDD4FBDCF1}"/>
                  </a:ext>
                </a:extLst>
              </p:cNvPr>
              <p:cNvSpPr txBox="1"/>
              <p:nvPr/>
            </p:nvSpPr>
            <p:spPr>
              <a:xfrm rot="16200000">
                <a:off x="6750916" y="4362600"/>
                <a:ext cx="10823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TRMT112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22174345-7E16-0268-F5F8-557AB03BEC2B}"/>
                  </a:ext>
                </a:extLst>
              </p:cNvPr>
              <p:cNvSpPr txBox="1"/>
              <p:nvPr/>
            </p:nvSpPr>
            <p:spPr>
              <a:xfrm rot="16200000">
                <a:off x="6740413" y="2028252"/>
                <a:ext cx="107766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dirty="0"/>
                  <a:t>α-</a:t>
                </a:r>
                <a:r>
                  <a:rPr lang="en-US" dirty="0"/>
                  <a:t>Tubulin</a:t>
                </a: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3432DBF-C868-82EA-AB35-CD6563AA9716}"/>
                  </a:ext>
                </a:extLst>
              </p:cNvPr>
              <p:cNvSpPr txBox="1"/>
              <p:nvPr/>
            </p:nvSpPr>
            <p:spPr>
              <a:xfrm>
                <a:off x="8385503" y="371181"/>
                <a:ext cx="97174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/>
                  <a:t>MCF10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57B1FB3-84F1-2912-FB7C-281D3917D2E1}"/>
                  </a:ext>
                </a:extLst>
              </p:cNvPr>
              <p:cNvSpPr txBox="1"/>
              <p:nvPr/>
            </p:nvSpPr>
            <p:spPr>
              <a:xfrm rot="18298766">
                <a:off x="8399538" y="948846"/>
                <a:ext cx="39324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AT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2C3D6967-BBAC-A918-2033-4FAA4B645273}"/>
                  </a:ext>
                </a:extLst>
              </p:cNvPr>
              <p:cNvSpPr txBox="1"/>
              <p:nvPr/>
            </p:nvSpPr>
            <p:spPr>
              <a:xfrm rot="18298766">
                <a:off x="8695941" y="901859"/>
                <a:ext cx="66434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CA1a</a:t>
                </a:r>
              </a:p>
            </p:txBody>
          </p:sp>
          <p:cxnSp>
            <p:nvCxnSpPr>
              <p:cNvPr id="11" name="Straight Connector 10">
                <a:extLst>
                  <a:ext uri="{FF2B5EF4-FFF2-40B4-BE49-F238E27FC236}">
                    <a16:creationId xmlns:a16="http://schemas.microsoft.com/office/drawing/2014/main" id="{B27F0EBE-C943-D184-F150-B94296A27711}"/>
                  </a:ext>
                </a:extLst>
              </p:cNvPr>
              <p:cNvCxnSpPr/>
              <p:nvPr/>
            </p:nvCxnSpPr>
            <p:spPr>
              <a:xfrm flipH="1">
                <a:off x="8481823" y="778122"/>
                <a:ext cx="73152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B8B8115-8DDE-9D50-D1C6-7AD632DA6C74}"/>
                  </a:ext>
                </a:extLst>
              </p:cNvPr>
              <p:cNvSpPr txBox="1"/>
              <p:nvPr/>
            </p:nvSpPr>
            <p:spPr>
              <a:xfrm rot="18298766">
                <a:off x="9499162" y="832721"/>
                <a:ext cx="705642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MCF7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6E58969-0891-798E-2CA6-20731067FB0D}"/>
                  </a:ext>
                </a:extLst>
              </p:cNvPr>
              <p:cNvSpPr txBox="1"/>
              <p:nvPr/>
            </p:nvSpPr>
            <p:spPr>
              <a:xfrm rot="18298766">
                <a:off x="9766894" y="677419"/>
                <a:ext cx="121219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MCF7-5624</a:t>
                </a:r>
              </a:p>
            </p:txBody>
          </p: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B54EF5DA-C689-21A9-75A9-59D3876C310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690498" y="4321114"/>
                <a:ext cx="13716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727B208-4EF3-2FC7-F9D2-CB6C42270C73}"/>
                  </a:ext>
                </a:extLst>
              </p:cNvPr>
              <p:cNvSpPr txBox="1"/>
              <p:nvPr/>
            </p:nvSpPr>
            <p:spPr>
              <a:xfrm>
                <a:off x="10791015" y="4161167"/>
                <a:ext cx="69762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14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1497F32F-DD73-881E-F4D2-01A39A78BA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688440" y="2003959"/>
                <a:ext cx="13716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A1ADC0C-CF41-004F-97CB-C54531CBC9BA}"/>
                  </a:ext>
                </a:extLst>
              </p:cNvPr>
              <p:cNvSpPr txBox="1"/>
              <p:nvPr/>
            </p:nvSpPr>
            <p:spPr>
              <a:xfrm>
                <a:off x="10779930" y="1855100"/>
                <a:ext cx="7359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5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pic>
            <p:nvPicPr>
              <p:cNvPr id="63" name="Content Placeholder 12" descr="A black and white image of a person's body&#10;&#10;Description automatically generated">
                <a:extLst>
                  <a:ext uri="{FF2B5EF4-FFF2-40B4-BE49-F238E27FC236}">
                    <a16:creationId xmlns:a16="http://schemas.microsoft.com/office/drawing/2014/main" id="{FFFA0B50-23D6-A282-6ED9-30AE5D13812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3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96" t="46108" r="24493" b="40498"/>
              <a:stretch/>
            </p:blipFill>
            <p:spPr>
              <a:xfrm>
                <a:off x="7756266" y="4844910"/>
                <a:ext cx="2602567" cy="54923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4" name="Picture 63" descr="A blurry image of a line&#10;&#10;Description automatically generated">
                <a:extLst>
                  <a:ext uri="{FF2B5EF4-FFF2-40B4-BE49-F238E27FC236}">
                    <a16:creationId xmlns:a16="http://schemas.microsoft.com/office/drawing/2014/main" id="{E0E38788-3ED9-7238-3ACA-492D19F756E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3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115" t="43511" r="22524" b="43095"/>
              <a:stretch/>
            </p:blipFill>
            <p:spPr>
              <a:xfrm>
                <a:off x="7807221" y="2867182"/>
                <a:ext cx="2527989" cy="60505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7CB7D139-41D0-414F-7B2B-1448B155ABF9}"/>
                  </a:ext>
                </a:extLst>
              </p:cNvPr>
              <p:cNvSpPr txBox="1"/>
              <p:nvPr/>
            </p:nvSpPr>
            <p:spPr>
              <a:xfrm>
                <a:off x="10606825" y="2238383"/>
                <a:ext cx="5166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JPEG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B73ABDC4-0126-1060-DB1B-1199D094F9DC}"/>
                  </a:ext>
                </a:extLst>
              </p:cNvPr>
              <p:cNvSpPr txBox="1"/>
              <p:nvPr/>
            </p:nvSpPr>
            <p:spPr>
              <a:xfrm>
                <a:off x="10590615" y="2985454"/>
                <a:ext cx="3786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IF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F6D3935-AE03-AC8D-BFD6-3BB59CF5B296}"/>
                  </a:ext>
                </a:extLst>
              </p:cNvPr>
              <p:cNvSpPr txBox="1"/>
              <p:nvPr/>
            </p:nvSpPr>
            <p:spPr>
              <a:xfrm>
                <a:off x="10654553" y="4426732"/>
                <a:ext cx="5166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JPEG</a:t>
                </a:r>
              </a:p>
            </p:txBody>
          </p: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D44EF3FF-328B-669A-88C1-6FEE43917A71}"/>
                  </a:ext>
                </a:extLst>
              </p:cNvPr>
              <p:cNvSpPr txBox="1"/>
              <p:nvPr/>
            </p:nvSpPr>
            <p:spPr>
              <a:xfrm>
                <a:off x="10638343" y="4983744"/>
                <a:ext cx="3786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IF</a:t>
                </a:r>
              </a:p>
            </p:txBody>
          </p:sp>
        </p:grp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6AEB9A14-AAD9-D391-FDE4-CCED9AFBC9E0}"/>
                </a:ext>
              </a:extLst>
            </p:cNvPr>
            <p:cNvSpPr/>
            <p:nvPr/>
          </p:nvSpPr>
          <p:spPr>
            <a:xfrm>
              <a:off x="9571649" y="2056600"/>
              <a:ext cx="1001214" cy="456826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6281665D-E8F3-7B6E-4132-CDEE52CC6A23}"/>
                </a:ext>
              </a:extLst>
            </p:cNvPr>
            <p:cNvSpPr/>
            <p:nvPr/>
          </p:nvSpPr>
          <p:spPr>
            <a:xfrm>
              <a:off x="8290507" y="2048810"/>
              <a:ext cx="854260" cy="456826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42" name="Rectangle 41">
            <a:extLst>
              <a:ext uri="{FF2B5EF4-FFF2-40B4-BE49-F238E27FC236}">
                <a16:creationId xmlns:a16="http://schemas.microsoft.com/office/drawing/2014/main" id="{6F6460C7-2468-1220-905B-D07F39907F63}"/>
              </a:ext>
            </a:extLst>
          </p:cNvPr>
          <p:cNvSpPr/>
          <p:nvPr/>
        </p:nvSpPr>
        <p:spPr>
          <a:xfrm>
            <a:off x="756694" y="2638981"/>
            <a:ext cx="4173134" cy="718111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431950EC-BBDE-3349-1B4B-F041452108B6}"/>
              </a:ext>
            </a:extLst>
          </p:cNvPr>
          <p:cNvSpPr/>
          <p:nvPr/>
        </p:nvSpPr>
        <p:spPr>
          <a:xfrm>
            <a:off x="779887" y="4779208"/>
            <a:ext cx="4173134" cy="718111"/>
          </a:xfrm>
          <a:prstGeom prst="rect">
            <a:avLst/>
          </a:prstGeom>
          <a:noFill/>
          <a:ln>
            <a:prstDash val="dash"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340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TextBox 125">
            <a:extLst>
              <a:ext uri="{FF2B5EF4-FFF2-40B4-BE49-F238E27FC236}">
                <a16:creationId xmlns:a16="http://schemas.microsoft.com/office/drawing/2014/main" id="{28D01457-F917-5809-DDE6-EA1B4F6EA6B4}"/>
              </a:ext>
            </a:extLst>
          </p:cNvPr>
          <p:cNvSpPr txBox="1"/>
          <p:nvPr/>
        </p:nvSpPr>
        <p:spPr>
          <a:xfrm>
            <a:off x="128000" y="50149"/>
            <a:ext cx="225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Figure 5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E013B248-E07C-C02A-322B-2C2152735A3C}"/>
              </a:ext>
            </a:extLst>
          </p:cNvPr>
          <p:cNvGrpSpPr/>
          <p:nvPr/>
        </p:nvGrpSpPr>
        <p:grpSpPr>
          <a:xfrm>
            <a:off x="119070" y="1036320"/>
            <a:ext cx="4274601" cy="4861560"/>
            <a:chOff x="119070" y="1036320"/>
            <a:chExt cx="4274601" cy="4861560"/>
          </a:xfrm>
        </p:grpSpPr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5FBFC780-0700-9965-4089-89514C8CCB86}"/>
                </a:ext>
              </a:extLst>
            </p:cNvPr>
            <p:cNvGrpSpPr/>
            <p:nvPr/>
          </p:nvGrpSpPr>
          <p:grpSpPr>
            <a:xfrm>
              <a:off x="119070" y="1036320"/>
              <a:ext cx="4274601" cy="4839896"/>
              <a:chOff x="155119" y="955205"/>
              <a:chExt cx="4274601" cy="4839896"/>
            </a:xfrm>
          </p:grpSpPr>
          <p:pic>
            <p:nvPicPr>
              <p:cNvPr id="20" name="Picture 19" descr="A close-up of a test tube&#10;&#10;Description automatically generated">
                <a:extLst>
                  <a:ext uri="{FF2B5EF4-FFF2-40B4-BE49-F238E27FC236}">
                    <a16:creationId xmlns:a16="http://schemas.microsoft.com/office/drawing/2014/main" id="{01BA3B62-2664-A7EA-FEAA-16B175F2CE4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8516" r="-1245" b="43513"/>
              <a:stretch/>
            </p:blipFill>
            <p:spPr>
              <a:xfrm>
                <a:off x="583406" y="3668428"/>
                <a:ext cx="3047520" cy="1079331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16C5945-3241-BABD-217E-EE0F473693A6}"/>
                  </a:ext>
                </a:extLst>
              </p:cNvPr>
              <p:cNvSpPr txBox="1"/>
              <p:nvPr/>
            </p:nvSpPr>
            <p:spPr>
              <a:xfrm rot="16200000">
                <a:off x="-201389" y="4563093"/>
                <a:ext cx="108234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TRMT112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EBDE24C3-E7F1-88BF-79E6-BF191D99D903}"/>
                  </a:ext>
                </a:extLst>
              </p:cNvPr>
              <p:cNvSpPr txBox="1"/>
              <p:nvPr/>
            </p:nvSpPr>
            <p:spPr>
              <a:xfrm>
                <a:off x="929859" y="1016738"/>
                <a:ext cx="1001300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MDA-231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97046879-C722-538F-32DF-1568CE37EADE}"/>
                  </a:ext>
                </a:extLst>
              </p:cNvPr>
              <p:cNvSpPr txBox="1"/>
              <p:nvPr/>
            </p:nvSpPr>
            <p:spPr>
              <a:xfrm>
                <a:off x="1873059" y="999805"/>
                <a:ext cx="928459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SUM159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64A58AD4-35AD-A312-3ED4-0085035762F8}"/>
                  </a:ext>
                </a:extLst>
              </p:cNvPr>
              <p:cNvSpPr txBox="1"/>
              <p:nvPr/>
            </p:nvSpPr>
            <p:spPr>
              <a:xfrm rot="18837489">
                <a:off x="1074153" y="1436850"/>
                <a:ext cx="4458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EV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A64489E-4AA8-AF4D-3683-D985A8831AC9}"/>
                  </a:ext>
                </a:extLst>
              </p:cNvPr>
              <p:cNvSpPr txBox="1"/>
              <p:nvPr/>
            </p:nvSpPr>
            <p:spPr>
              <a:xfrm rot="18837489">
                <a:off x="1360426" y="1437451"/>
                <a:ext cx="4475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KD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E0CAF292-6DB3-9F57-CB3A-5F6FC3C5918C}"/>
                  </a:ext>
                </a:extLst>
              </p:cNvPr>
              <p:cNvSpPr txBox="1"/>
              <p:nvPr/>
            </p:nvSpPr>
            <p:spPr>
              <a:xfrm rot="18837489">
                <a:off x="1929590" y="1405160"/>
                <a:ext cx="44589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EV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43B0952-D172-205C-3548-19E666C2FABC}"/>
                  </a:ext>
                </a:extLst>
              </p:cNvPr>
              <p:cNvSpPr txBox="1"/>
              <p:nvPr/>
            </p:nvSpPr>
            <p:spPr>
              <a:xfrm rot="18837489">
                <a:off x="2236726" y="1436901"/>
                <a:ext cx="44755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KD</a:t>
                </a:r>
              </a:p>
            </p:txBody>
          </p: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F14277DD-3FDD-1294-7A91-E3CB25ED7820}"/>
                  </a:ext>
                </a:extLst>
              </p:cNvPr>
              <p:cNvCxnSpPr/>
              <p:nvPr/>
            </p:nvCxnSpPr>
            <p:spPr>
              <a:xfrm flipH="1">
                <a:off x="1110469" y="1338770"/>
                <a:ext cx="640080" cy="0"/>
              </a:xfrm>
              <a:prstGeom prst="line">
                <a:avLst/>
              </a:prstGeom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15A741EC-54E4-F6DD-1AD5-413D7067187C}"/>
                  </a:ext>
                </a:extLst>
              </p:cNvPr>
              <p:cNvCxnSpPr/>
              <p:nvPr/>
            </p:nvCxnSpPr>
            <p:spPr>
              <a:xfrm flipH="1">
                <a:off x="1992532" y="1333794"/>
                <a:ext cx="640080" cy="0"/>
              </a:xfrm>
              <a:prstGeom prst="line">
                <a:avLst/>
              </a:prstGeom>
              <a:ln>
                <a:solidFill>
                  <a:srgbClr val="C00000"/>
                </a:solidFill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80821F43-6656-33AB-B6B5-4F9D06E050DF}"/>
                  </a:ext>
                </a:extLst>
              </p:cNvPr>
              <p:cNvSpPr txBox="1"/>
              <p:nvPr/>
            </p:nvSpPr>
            <p:spPr>
              <a:xfrm>
                <a:off x="2804147" y="955205"/>
                <a:ext cx="7675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BT549</a:t>
                </a:r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7974F052-D7E1-AB58-FCCD-E20BD11B19DE}"/>
                  </a:ext>
                </a:extLst>
              </p:cNvPr>
              <p:cNvSpPr txBox="1"/>
              <p:nvPr/>
            </p:nvSpPr>
            <p:spPr>
              <a:xfrm rot="18837489">
                <a:off x="2793687" y="1397002"/>
                <a:ext cx="42832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EV</a:t>
                </a:r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A5A14CA1-3FEF-E570-8535-5A8E90B12B77}"/>
                  </a:ext>
                </a:extLst>
              </p:cNvPr>
              <p:cNvSpPr txBox="1"/>
              <p:nvPr/>
            </p:nvSpPr>
            <p:spPr>
              <a:xfrm rot="18837489">
                <a:off x="3194747" y="1422787"/>
                <a:ext cx="44916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OE</a:t>
                </a:r>
              </a:p>
            </p:txBody>
          </p: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3D18A163-D9B0-3E5E-5285-C35E48E4E98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875513" y="1334124"/>
                <a:ext cx="688577" cy="0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3">
                <a:schemeClr val="accent1"/>
              </a:lnRef>
              <a:fillRef idx="0">
                <a:schemeClr val="accent1"/>
              </a:fillRef>
              <a:effectRef idx="2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6" name="TextBox 55">
                <a:extLst>
                  <a:ext uri="{FF2B5EF4-FFF2-40B4-BE49-F238E27FC236}">
                    <a16:creationId xmlns:a16="http://schemas.microsoft.com/office/drawing/2014/main" id="{AAE3291F-2E6B-B049-2587-035B0824CE8A}"/>
                  </a:ext>
                </a:extLst>
              </p:cNvPr>
              <p:cNvSpPr txBox="1"/>
              <p:nvPr/>
            </p:nvSpPr>
            <p:spPr>
              <a:xfrm rot="16200000">
                <a:off x="-213118" y="2348767"/>
                <a:ext cx="110953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dirty="0">
                    <a:latin typeface="Aptos" panose="020B0004020202020204" pitchFamily="34" charset="0"/>
                  </a:rPr>
                  <a:t>α</a:t>
                </a:r>
                <a:r>
                  <a:rPr lang="en-US" dirty="0">
                    <a:latin typeface="Aptos" panose="020B0004020202020204" pitchFamily="34" charset="0"/>
                  </a:rPr>
                  <a:t>-</a:t>
                </a:r>
                <a:r>
                  <a:rPr lang="en-US" dirty="0"/>
                  <a:t>Tubulin</a:t>
                </a:r>
              </a:p>
            </p:txBody>
          </p:sp>
          <p:cxnSp>
            <p:nvCxnSpPr>
              <p:cNvPr id="65" name="Straight Connector 64">
                <a:extLst>
                  <a:ext uri="{FF2B5EF4-FFF2-40B4-BE49-F238E27FC236}">
                    <a16:creationId xmlns:a16="http://schemas.microsoft.com/office/drawing/2014/main" id="{E24814BA-0C90-E169-1D0A-6CED0FE33A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84511" y="4027138"/>
                <a:ext cx="13716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02DE13F9-9DDE-38C4-6E52-DB137FB0760B}"/>
                  </a:ext>
                </a:extLst>
              </p:cNvPr>
              <p:cNvSpPr txBox="1"/>
              <p:nvPr/>
            </p:nvSpPr>
            <p:spPr>
              <a:xfrm>
                <a:off x="3697813" y="3879926"/>
                <a:ext cx="69762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14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67" name="Straight Connector 66">
                <a:extLst>
                  <a:ext uri="{FF2B5EF4-FFF2-40B4-BE49-F238E27FC236}">
                    <a16:creationId xmlns:a16="http://schemas.microsoft.com/office/drawing/2014/main" id="{800AD3C1-0699-15FA-144E-531126FC889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77107" y="2204853"/>
                <a:ext cx="13716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8" name="TextBox 67">
                <a:extLst>
                  <a:ext uri="{FF2B5EF4-FFF2-40B4-BE49-F238E27FC236}">
                    <a16:creationId xmlns:a16="http://schemas.microsoft.com/office/drawing/2014/main" id="{0B10B8F4-0162-AC35-BFD9-BAE5757D2868}"/>
                  </a:ext>
                </a:extLst>
              </p:cNvPr>
              <p:cNvSpPr txBox="1"/>
              <p:nvPr/>
            </p:nvSpPr>
            <p:spPr>
              <a:xfrm>
                <a:off x="3693813" y="2026865"/>
                <a:ext cx="7359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5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pic>
            <p:nvPicPr>
              <p:cNvPr id="26" name="Picture 25" descr="A line of black dots&#10;&#10;AI-generated content may be incorrect.">
                <a:extLst>
                  <a:ext uri="{FF2B5EF4-FFF2-40B4-BE49-F238E27FC236}">
                    <a16:creationId xmlns:a16="http://schemas.microsoft.com/office/drawing/2014/main" id="{352C40E7-C16B-0A58-5C10-85588676996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-26000" contrast="2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49801" b="29953"/>
              <a:stretch/>
            </p:blipFill>
            <p:spPr>
              <a:xfrm>
                <a:off x="581792" y="2605589"/>
                <a:ext cx="2982298" cy="830213"/>
              </a:xfrm>
              <a:prstGeom prst="rect">
                <a:avLst/>
              </a:prstGeom>
            </p:spPr>
          </p:pic>
          <p:pic>
            <p:nvPicPr>
              <p:cNvPr id="28" name="Picture 27" descr="A close-up of a test strip&#10;&#10;AI-generated content may be incorrect.">
                <a:extLst>
                  <a:ext uri="{FF2B5EF4-FFF2-40B4-BE49-F238E27FC236}">
                    <a16:creationId xmlns:a16="http://schemas.microsoft.com/office/drawing/2014/main" id="{3C0E3788-9551-9C77-9CEC-218BD49ED9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2019" b="29654"/>
              <a:stretch/>
            </p:blipFill>
            <p:spPr>
              <a:xfrm>
                <a:off x="600845" y="1817736"/>
                <a:ext cx="2981992" cy="751449"/>
              </a:xfrm>
              <a:prstGeom prst="rect">
                <a:avLst/>
              </a:prstGeom>
            </p:spPr>
          </p:pic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id="{490C5945-0E02-C0D3-3A7F-7804734BB4A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57348" y="3026029"/>
                <a:ext cx="13716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C5C4216-6CF6-9DB9-9196-AED737669B4D}"/>
                  </a:ext>
                </a:extLst>
              </p:cNvPr>
              <p:cNvSpPr txBox="1"/>
              <p:nvPr/>
            </p:nvSpPr>
            <p:spPr>
              <a:xfrm>
                <a:off x="3674054" y="2848041"/>
                <a:ext cx="73590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5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87B37884-AADA-9498-B0C5-AB14428BF5D2}"/>
                  </a:ext>
                </a:extLst>
              </p:cNvPr>
              <p:cNvSpPr txBox="1"/>
              <p:nvPr/>
            </p:nvSpPr>
            <p:spPr>
              <a:xfrm>
                <a:off x="3551235" y="2270755"/>
                <a:ext cx="5166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JPEG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A4449653-7563-041C-A1A1-F2CF3B395788}"/>
                  </a:ext>
                </a:extLst>
              </p:cNvPr>
              <p:cNvSpPr txBox="1"/>
              <p:nvPr/>
            </p:nvSpPr>
            <p:spPr>
              <a:xfrm>
                <a:off x="3569939" y="4240166"/>
                <a:ext cx="5166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JPEG</a:t>
                </a:r>
              </a:p>
            </p:txBody>
          </p:sp>
          <p:pic>
            <p:nvPicPr>
              <p:cNvPr id="40" name="Picture 39" descr="A blurry image of a person's foot&#10;&#10;AI-generated content may be incorrect.">
                <a:extLst>
                  <a:ext uri="{FF2B5EF4-FFF2-40B4-BE49-F238E27FC236}">
                    <a16:creationId xmlns:a16="http://schemas.microsoft.com/office/drawing/2014/main" id="{EF6731B3-3798-EF75-EE3B-D5E67CE028C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30000" contras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5727" b="51240"/>
              <a:stretch/>
            </p:blipFill>
            <p:spPr>
              <a:xfrm>
                <a:off x="594809" y="4832310"/>
                <a:ext cx="2982298" cy="944492"/>
              </a:xfrm>
              <a:prstGeom prst="rect">
                <a:avLst/>
              </a:prstGeom>
            </p:spPr>
          </p:pic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A7198BA2-FCD1-0422-1CE8-FF3674A73B99}"/>
                  </a:ext>
                </a:extLst>
              </p:cNvPr>
              <p:cNvSpPr txBox="1"/>
              <p:nvPr/>
            </p:nvSpPr>
            <p:spPr>
              <a:xfrm>
                <a:off x="3556752" y="3127915"/>
                <a:ext cx="3786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IF</a:t>
                </a:r>
              </a:p>
            </p:txBody>
          </p:sp>
          <p:cxnSp>
            <p:nvCxnSpPr>
              <p:cNvPr id="42" name="Straight Connector 41">
                <a:extLst>
                  <a:ext uri="{FF2B5EF4-FFF2-40B4-BE49-F238E27FC236}">
                    <a16:creationId xmlns:a16="http://schemas.microsoft.com/office/drawing/2014/main" id="{081070E3-ABF2-447C-5A47-7C2CBB9DD16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61048" y="5305074"/>
                <a:ext cx="13716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6DE1A558-ACAD-C30A-6D71-8ED01CAB3B37}"/>
                  </a:ext>
                </a:extLst>
              </p:cNvPr>
              <p:cNvSpPr txBox="1"/>
              <p:nvPr/>
            </p:nvSpPr>
            <p:spPr>
              <a:xfrm>
                <a:off x="3674350" y="5157862"/>
                <a:ext cx="69762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14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56F16364-9CD6-23B3-2666-ACA845014F8B}"/>
                  </a:ext>
                </a:extLst>
              </p:cNvPr>
              <p:cNvSpPr txBox="1"/>
              <p:nvPr/>
            </p:nvSpPr>
            <p:spPr>
              <a:xfrm>
                <a:off x="3546476" y="5518102"/>
                <a:ext cx="3786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TIF</a:t>
                </a:r>
              </a:p>
            </p:txBody>
          </p:sp>
        </p:grp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5B580539-FFAD-CE61-F2C2-0E03C256E2E0}"/>
                </a:ext>
              </a:extLst>
            </p:cNvPr>
            <p:cNvSpPr/>
            <p:nvPr/>
          </p:nvSpPr>
          <p:spPr>
            <a:xfrm>
              <a:off x="2682240" y="1859280"/>
              <a:ext cx="853440" cy="403860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826D3F91-3744-D016-9360-EEB1B92F0401}"/>
                </a:ext>
              </a:extLst>
            </p:cNvPr>
            <p:cNvSpPr/>
            <p:nvPr/>
          </p:nvSpPr>
          <p:spPr>
            <a:xfrm>
              <a:off x="1981200" y="1859280"/>
              <a:ext cx="701040" cy="403860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49FC3934-4691-7916-D471-3789079F16DC}"/>
                </a:ext>
              </a:extLst>
            </p:cNvPr>
            <p:cNvSpPr/>
            <p:nvPr/>
          </p:nvSpPr>
          <p:spPr>
            <a:xfrm>
              <a:off x="1097280" y="1859280"/>
              <a:ext cx="594360" cy="403860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8" name="Group 127">
            <a:extLst>
              <a:ext uri="{FF2B5EF4-FFF2-40B4-BE49-F238E27FC236}">
                <a16:creationId xmlns:a16="http://schemas.microsoft.com/office/drawing/2014/main" id="{2FB52D27-ADC3-7A7E-089E-A82E3265B3BA}"/>
              </a:ext>
            </a:extLst>
          </p:cNvPr>
          <p:cNvGrpSpPr/>
          <p:nvPr/>
        </p:nvGrpSpPr>
        <p:grpSpPr>
          <a:xfrm>
            <a:off x="5061497" y="419481"/>
            <a:ext cx="6941033" cy="6098425"/>
            <a:chOff x="5061497" y="419481"/>
            <a:chExt cx="6941033" cy="6098425"/>
          </a:xfrm>
        </p:grpSpPr>
        <p:pic>
          <p:nvPicPr>
            <p:cNvPr id="70" name="Picture 69" descr="A close-up of a test tube&#10;&#10;AI-generated content may be incorrect.">
              <a:extLst>
                <a:ext uri="{FF2B5EF4-FFF2-40B4-BE49-F238E27FC236}">
                  <a16:creationId xmlns:a16="http://schemas.microsoft.com/office/drawing/2014/main" id="{528C9738-631F-2A1F-8313-86AF9086523A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7941" r="16372" b="21097"/>
            <a:stretch/>
          </p:blipFill>
          <p:spPr>
            <a:xfrm>
              <a:off x="5956233" y="4313354"/>
              <a:ext cx="2875177" cy="2174629"/>
            </a:xfrm>
            <a:prstGeom prst="rect">
              <a:avLst/>
            </a:prstGeom>
          </p:spPr>
        </p:pic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2DEFB78-6583-5FAF-219A-7D582C188A90}"/>
                </a:ext>
              </a:extLst>
            </p:cNvPr>
            <p:cNvSpPr txBox="1"/>
            <p:nvPr/>
          </p:nvSpPr>
          <p:spPr>
            <a:xfrm>
              <a:off x="6169996" y="1013205"/>
              <a:ext cx="856392" cy="290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DA-231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3220B22E-930A-79C5-C333-4958BB9A17F9}"/>
                </a:ext>
              </a:extLst>
            </p:cNvPr>
            <p:cNvSpPr txBox="1"/>
            <p:nvPr/>
          </p:nvSpPr>
          <p:spPr>
            <a:xfrm>
              <a:off x="7113170" y="1016028"/>
              <a:ext cx="794093" cy="290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SUM159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9FF7C91A-F638-A270-94F2-C5E4DF01303B}"/>
                </a:ext>
              </a:extLst>
            </p:cNvPr>
            <p:cNvSpPr txBox="1"/>
            <p:nvPr/>
          </p:nvSpPr>
          <p:spPr>
            <a:xfrm rot="18837489">
              <a:off x="6432392" y="1380219"/>
              <a:ext cx="382219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V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A57B140F-0B1D-5677-8B95-3C1B9B0A3006}"/>
                </a:ext>
              </a:extLst>
            </p:cNvPr>
            <p:cNvSpPr txBox="1"/>
            <p:nvPr/>
          </p:nvSpPr>
          <p:spPr>
            <a:xfrm rot="18837489">
              <a:off x="6722411" y="1380735"/>
              <a:ext cx="383648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D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CED88A81-E45B-0AEE-A8AE-E69325A66738}"/>
                </a:ext>
              </a:extLst>
            </p:cNvPr>
            <p:cNvSpPr txBox="1"/>
            <p:nvPr/>
          </p:nvSpPr>
          <p:spPr>
            <a:xfrm rot="18837489">
              <a:off x="7085185" y="1385380"/>
              <a:ext cx="382219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V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C06CEBC8-6C86-3D9A-2467-9FD26B9C19F9}"/>
                </a:ext>
              </a:extLst>
            </p:cNvPr>
            <p:cNvSpPr txBox="1"/>
            <p:nvPr/>
          </p:nvSpPr>
          <p:spPr>
            <a:xfrm rot="18837489">
              <a:off x="7354498" y="1362888"/>
              <a:ext cx="383648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D</a:t>
              </a:r>
            </a:p>
          </p:txBody>
        </p:sp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id="{A69B8BBC-76CD-16D0-33E3-80674F8507E2}"/>
                </a:ext>
              </a:extLst>
            </p:cNvPr>
            <p:cNvCxnSpPr/>
            <p:nvPr/>
          </p:nvCxnSpPr>
          <p:spPr>
            <a:xfrm flipH="1">
              <a:off x="6473880" y="1342938"/>
              <a:ext cx="547448" cy="0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9BEF7ABC-AAE5-E75D-6832-4CDF1DB9F5FF}"/>
                </a:ext>
              </a:extLst>
            </p:cNvPr>
            <p:cNvCxnSpPr/>
            <p:nvPr/>
          </p:nvCxnSpPr>
          <p:spPr>
            <a:xfrm flipH="1">
              <a:off x="7150572" y="1331512"/>
              <a:ext cx="54744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F19CEB54-5F84-2C26-41A9-4ADAB6B51981}"/>
                </a:ext>
              </a:extLst>
            </p:cNvPr>
            <p:cNvSpPr txBox="1"/>
            <p:nvPr/>
          </p:nvSpPr>
          <p:spPr>
            <a:xfrm>
              <a:off x="8124739" y="1004440"/>
              <a:ext cx="656498" cy="3165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T549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845E220B-3382-B4BD-BCB9-7FDF16DFA752}"/>
                </a:ext>
              </a:extLst>
            </p:cNvPr>
            <p:cNvSpPr txBox="1"/>
            <p:nvPr/>
          </p:nvSpPr>
          <p:spPr>
            <a:xfrm rot="18837489">
              <a:off x="8015784" y="1367464"/>
              <a:ext cx="367159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V</a:t>
              </a:r>
            </a:p>
          </p:txBody>
        </p:sp>
        <p:sp>
          <p:nvSpPr>
            <p:cNvPr id="88" name="TextBox 87">
              <a:extLst>
                <a:ext uri="{FF2B5EF4-FFF2-40B4-BE49-F238E27FC236}">
                  <a16:creationId xmlns:a16="http://schemas.microsoft.com/office/drawing/2014/main" id="{0EC7CC1B-5817-EACD-CF8E-5B1627F8924F}"/>
                </a:ext>
              </a:extLst>
            </p:cNvPr>
            <p:cNvSpPr txBox="1"/>
            <p:nvPr/>
          </p:nvSpPr>
          <p:spPr>
            <a:xfrm rot="18837489">
              <a:off x="8388242" y="1402631"/>
              <a:ext cx="385023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E</a:t>
              </a:r>
            </a:p>
          </p:txBody>
        </p:sp>
        <p:cxnSp>
          <p:nvCxnSpPr>
            <p:cNvPr id="89" name="Straight Connector 88">
              <a:extLst>
                <a:ext uri="{FF2B5EF4-FFF2-40B4-BE49-F238E27FC236}">
                  <a16:creationId xmlns:a16="http://schemas.microsoft.com/office/drawing/2014/main" id="{6B4F439C-2035-78D4-0D4B-2BBB2502EDE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48496" y="1331381"/>
              <a:ext cx="58892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>
              <a:extLst>
                <a:ext uri="{FF2B5EF4-FFF2-40B4-BE49-F238E27FC236}">
                  <a16:creationId xmlns:a16="http://schemas.microsoft.com/office/drawing/2014/main" id="{D040EDE3-376F-9EDA-E958-A1C0533E3F16}"/>
                </a:ext>
              </a:extLst>
            </p:cNvPr>
            <p:cNvCxnSpPr>
              <a:cxnSpLocks/>
            </p:cNvCxnSpPr>
            <p:nvPr/>
          </p:nvCxnSpPr>
          <p:spPr>
            <a:xfrm>
              <a:off x="5831448" y="2021896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93FDE7B5-B642-BC34-9634-2CEAC2AAA445}"/>
                </a:ext>
              </a:extLst>
            </p:cNvPr>
            <p:cNvSpPr txBox="1"/>
            <p:nvPr/>
          </p:nvSpPr>
          <p:spPr>
            <a:xfrm>
              <a:off x="5064793" y="1825013"/>
              <a:ext cx="711668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B40EFC20-DC94-8AAE-F275-BF9438107B46}"/>
                </a:ext>
              </a:extLst>
            </p:cNvPr>
            <p:cNvCxnSpPr>
              <a:cxnSpLocks/>
            </p:cNvCxnSpPr>
            <p:nvPr/>
          </p:nvCxnSpPr>
          <p:spPr>
            <a:xfrm>
              <a:off x="5831137" y="2182440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9C4AB1E6-0165-3A0F-1AD3-32BFB71CB01C}"/>
                </a:ext>
              </a:extLst>
            </p:cNvPr>
            <p:cNvSpPr txBox="1"/>
            <p:nvPr/>
          </p:nvSpPr>
          <p:spPr>
            <a:xfrm>
              <a:off x="5070613" y="2016990"/>
              <a:ext cx="711668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3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2D3E46DB-BDA4-A4EC-1B03-D7979C67342D}"/>
                </a:ext>
              </a:extLst>
            </p:cNvPr>
            <p:cNvCxnSpPr>
              <a:cxnSpLocks/>
            </p:cNvCxnSpPr>
            <p:nvPr/>
          </p:nvCxnSpPr>
          <p:spPr>
            <a:xfrm>
              <a:off x="5844019" y="2369981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57574F1B-9A86-1EF5-92EF-55CA28478E77}"/>
                </a:ext>
              </a:extLst>
            </p:cNvPr>
            <p:cNvSpPr txBox="1"/>
            <p:nvPr/>
          </p:nvSpPr>
          <p:spPr>
            <a:xfrm>
              <a:off x="5077052" y="2204531"/>
              <a:ext cx="711668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0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3A111165-B077-10E6-40C9-DD4B91444B37}"/>
                </a:ext>
              </a:extLst>
            </p:cNvPr>
            <p:cNvCxnSpPr>
              <a:cxnSpLocks/>
            </p:cNvCxnSpPr>
            <p:nvPr/>
          </p:nvCxnSpPr>
          <p:spPr>
            <a:xfrm>
              <a:off x="5844186" y="2552424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D2BA73B5-28D4-69B1-B6B5-9348604DAB5D}"/>
                </a:ext>
              </a:extLst>
            </p:cNvPr>
            <p:cNvSpPr txBox="1"/>
            <p:nvPr/>
          </p:nvSpPr>
          <p:spPr>
            <a:xfrm>
              <a:off x="5176655" y="2386784"/>
              <a:ext cx="629407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70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id="{34BC95E4-409A-DE69-8F8D-527B68FFD7FC}"/>
                </a:ext>
              </a:extLst>
            </p:cNvPr>
            <p:cNvCxnSpPr>
              <a:cxnSpLocks/>
            </p:cNvCxnSpPr>
            <p:nvPr/>
          </p:nvCxnSpPr>
          <p:spPr>
            <a:xfrm>
              <a:off x="5851230" y="2787812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44988D05-5BCA-3F9F-76F0-4C268E3D24D5}"/>
                </a:ext>
              </a:extLst>
            </p:cNvPr>
            <p:cNvSpPr txBox="1"/>
            <p:nvPr/>
          </p:nvSpPr>
          <p:spPr>
            <a:xfrm>
              <a:off x="5183190" y="2634388"/>
              <a:ext cx="629407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5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04" name="Straight Connector 103">
              <a:extLst>
                <a:ext uri="{FF2B5EF4-FFF2-40B4-BE49-F238E27FC236}">
                  <a16:creationId xmlns:a16="http://schemas.microsoft.com/office/drawing/2014/main" id="{654C664F-92A9-C913-E36E-BE962E040ADE}"/>
                </a:ext>
              </a:extLst>
            </p:cNvPr>
            <p:cNvCxnSpPr>
              <a:cxnSpLocks/>
            </p:cNvCxnSpPr>
            <p:nvPr/>
          </p:nvCxnSpPr>
          <p:spPr>
            <a:xfrm>
              <a:off x="5837095" y="3231129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11B1FBFE-E895-CCEF-054E-9639CCEF0CEB}"/>
                </a:ext>
              </a:extLst>
            </p:cNvPr>
            <p:cNvSpPr txBox="1"/>
            <p:nvPr/>
          </p:nvSpPr>
          <p:spPr>
            <a:xfrm>
              <a:off x="5194526" y="3078837"/>
              <a:ext cx="629407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3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681822A0-A6B6-C6EC-2B7A-0813FCCD62CD}"/>
                </a:ext>
              </a:extLst>
            </p:cNvPr>
            <p:cNvCxnSpPr>
              <a:cxnSpLocks/>
            </p:cNvCxnSpPr>
            <p:nvPr/>
          </p:nvCxnSpPr>
          <p:spPr>
            <a:xfrm>
              <a:off x="5838923" y="3586080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0A1B95C-AF0A-4483-6911-057563AC6106}"/>
                </a:ext>
              </a:extLst>
            </p:cNvPr>
            <p:cNvSpPr txBox="1"/>
            <p:nvPr/>
          </p:nvSpPr>
          <p:spPr>
            <a:xfrm>
              <a:off x="5183286" y="3435447"/>
              <a:ext cx="629407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2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9540B434-FAE1-3461-C4CC-7AAAF66208DE}"/>
                </a:ext>
              </a:extLst>
            </p:cNvPr>
            <p:cNvCxnSpPr>
              <a:cxnSpLocks/>
            </p:cNvCxnSpPr>
            <p:nvPr/>
          </p:nvCxnSpPr>
          <p:spPr>
            <a:xfrm>
              <a:off x="5855682" y="4028868"/>
              <a:ext cx="11731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3D2780E8-FEB8-F79C-98A1-47C8C7AD4AFE}"/>
                </a:ext>
              </a:extLst>
            </p:cNvPr>
            <p:cNvSpPr txBox="1"/>
            <p:nvPr/>
          </p:nvSpPr>
          <p:spPr>
            <a:xfrm>
              <a:off x="5187041" y="3857671"/>
              <a:ext cx="629407" cy="26382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15 </a:t>
              </a:r>
              <a:r>
                <a:rPr lang="en-US" sz="1400" dirty="0" err="1"/>
                <a:t>KDa</a:t>
              </a:r>
              <a:endParaRPr lang="en-US" sz="1400" dirty="0"/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D55961FC-4C37-AF0D-608D-E95D514D1CA3}"/>
                </a:ext>
              </a:extLst>
            </p:cNvPr>
            <p:cNvSpPr txBox="1"/>
            <p:nvPr/>
          </p:nvSpPr>
          <p:spPr>
            <a:xfrm>
              <a:off x="9216189" y="1115635"/>
              <a:ext cx="856392" cy="290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DA-231</a:t>
              </a: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F424B236-863E-01EE-B528-4593AC8B893C}"/>
                </a:ext>
              </a:extLst>
            </p:cNvPr>
            <p:cNvSpPr txBox="1"/>
            <p:nvPr/>
          </p:nvSpPr>
          <p:spPr>
            <a:xfrm>
              <a:off x="9952551" y="1112426"/>
              <a:ext cx="794093" cy="29020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SUM159</a:t>
              </a: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3B9E0CF4-C0E1-10E2-C985-E24DDCA7008A}"/>
                </a:ext>
              </a:extLst>
            </p:cNvPr>
            <p:cNvSpPr txBox="1"/>
            <p:nvPr/>
          </p:nvSpPr>
          <p:spPr>
            <a:xfrm rot="18837489">
              <a:off x="9344548" y="1476110"/>
              <a:ext cx="382219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V</a:t>
              </a: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BB5C8ECF-6608-CF2D-B12F-FE3B43C3D4E8}"/>
                </a:ext>
              </a:extLst>
            </p:cNvPr>
            <p:cNvSpPr txBox="1"/>
            <p:nvPr/>
          </p:nvSpPr>
          <p:spPr>
            <a:xfrm rot="18837489">
              <a:off x="9634567" y="1476625"/>
              <a:ext cx="383648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D</a:t>
              </a: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EF9260EF-86A1-934E-4CFA-27B86CB498DF}"/>
                </a:ext>
              </a:extLst>
            </p:cNvPr>
            <p:cNvSpPr txBox="1"/>
            <p:nvPr/>
          </p:nvSpPr>
          <p:spPr>
            <a:xfrm rot="18837489">
              <a:off x="10007851" y="1460251"/>
              <a:ext cx="382219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V</a:t>
              </a: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AE1CD28E-8920-1BC1-E5A9-AA56F172CA3B}"/>
                </a:ext>
              </a:extLst>
            </p:cNvPr>
            <p:cNvSpPr txBox="1"/>
            <p:nvPr/>
          </p:nvSpPr>
          <p:spPr>
            <a:xfrm rot="18837489">
              <a:off x="10266654" y="1448269"/>
              <a:ext cx="383648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KD</a:t>
              </a:r>
            </a:p>
          </p:txBody>
        </p: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4C0FC5D4-7BBC-5B17-E4EC-297CE3538B94}"/>
                </a:ext>
              </a:extLst>
            </p:cNvPr>
            <p:cNvCxnSpPr/>
            <p:nvPr/>
          </p:nvCxnSpPr>
          <p:spPr>
            <a:xfrm flipH="1">
              <a:off x="9386036" y="1417809"/>
              <a:ext cx="547448" cy="0"/>
            </a:xfrm>
            <a:prstGeom prst="line">
              <a:avLst/>
            </a:prstGeom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6D765950-9330-E85E-D9E4-82DB080C3CBA}"/>
                </a:ext>
              </a:extLst>
            </p:cNvPr>
            <p:cNvCxnSpPr/>
            <p:nvPr/>
          </p:nvCxnSpPr>
          <p:spPr>
            <a:xfrm flipH="1">
              <a:off x="10073238" y="1437913"/>
              <a:ext cx="547448" cy="0"/>
            </a:xfrm>
            <a:prstGeom prst="line">
              <a:avLst/>
            </a:prstGeom>
            <a:ln>
              <a:solidFill>
                <a:srgbClr val="C00000"/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E8C3C96A-C82D-93C1-F78E-5E4CECA4FB80}"/>
                </a:ext>
              </a:extLst>
            </p:cNvPr>
            <p:cNvSpPr txBox="1"/>
            <p:nvPr/>
          </p:nvSpPr>
          <p:spPr>
            <a:xfrm>
              <a:off x="11107753" y="1099949"/>
              <a:ext cx="656498" cy="3165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T549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DC543E42-ADB2-8075-302B-8021D938D227}"/>
                </a:ext>
              </a:extLst>
            </p:cNvPr>
            <p:cNvSpPr txBox="1"/>
            <p:nvPr/>
          </p:nvSpPr>
          <p:spPr>
            <a:xfrm rot="18837489">
              <a:off x="11103900" y="1441952"/>
              <a:ext cx="367159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EV</a:t>
              </a: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1D02CBD6-8417-5C91-BB7E-9819715A0D8F}"/>
                </a:ext>
              </a:extLst>
            </p:cNvPr>
            <p:cNvSpPr txBox="1"/>
            <p:nvPr/>
          </p:nvSpPr>
          <p:spPr>
            <a:xfrm rot="18837489">
              <a:off x="11402785" y="1477119"/>
              <a:ext cx="385023" cy="31588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E</a:t>
              </a:r>
            </a:p>
          </p:txBody>
        </p:sp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D3232A71-DE6D-1D25-6DA6-EA2CB09F74C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1131509" y="1426890"/>
              <a:ext cx="588926" cy="0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3">
              <a:schemeClr val="accent1"/>
            </a:lnRef>
            <a:fillRef idx="0">
              <a:schemeClr val="accent1"/>
            </a:fillRef>
            <a:effectRef idx="2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Picture 6" descr="A close-up of a test tube&#10;&#10;AI-generated content may be incorrect.">
              <a:extLst>
                <a:ext uri="{FF2B5EF4-FFF2-40B4-BE49-F238E27FC236}">
                  <a16:creationId xmlns:a16="http://schemas.microsoft.com/office/drawing/2014/main" id="{6CBD3D83-6812-B01A-C03A-F68B1FEDED0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603" r="12764" b="23194"/>
            <a:stretch/>
          </p:blipFill>
          <p:spPr>
            <a:xfrm>
              <a:off x="5972992" y="1762273"/>
              <a:ext cx="2831627" cy="2406280"/>
            </a:xfrm>
            <a:prstGeom prst="rect">
              <a:avLst/>
            </a:prstGeom>
          </p:spPr>
        </p:pic>
        <p:pic>
          <p:nvPicPr>
            <p:cNvPr id="9" name="Picture 8" descr="A blurry image of a row of lines&#10;&#10;AI-generated content may be incorrect.">
              <a:extLst>
                <a:ext uri="{FF2B5EF4-FFF2-40B4-BE49-F238E27FC236}">
                  <a16:creationId xmlns:a16="http://schemas.microsoft.com/office/drawing/2014/main" id="{6B783453-910B-5A62-9C09-FA3D8F81F34D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-34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81" t="20299" r="12313" b="24806"/>
            <a:stretch/>
          </p:blipFill>
          <p:spPr>
            <a:xfrm>
              <a:off x="9170903" y="1780262"/>
              <a:ext cx="2831627" cy="2304438"/>
            </a:xfrm>
            <a:prstGeom prst="rect">
              <a:avLst/>
            </a:prstGeom>
          </p:spPr>
        </p:pic>
        <p:pic>
          <p:nvPicPr>
            <p:cNvPr id="13" name="Picture 12" descr="A blurry image of a line&#10;&#10;AI-generated content may be incorrect.">
              <a:extLst>
                <a:ext uri="{FF2B5EF4-FFF2-40B4-BE49-F238E27FC236}">
                  <a16:creationId xmlns:a16="http://schemas.microsoft.com/office/drawing/2014/main" id="{09C50BD6-3B0B-5858-F1EB-DBCB6B505A7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-30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75" t="40891" r="13831" b="40078"/>
            <a:stretch/>
          </p:blipFill>
          <p:spPr>
            <a:xfrm>
              <a:off x="9170903" y="4772101"/>
              <a:ext cx="2779410" cy="91502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048EE24-0F4B-3DB9-2445-8948A5966525}"/>
                </a:ext>
              </a:extLst>
            </p:cNvPr>
            <p:cNvSpPr txBox="1"/>
            <p:nvPr/>
          </p:nvSpPr>
          <p:spPr>
            <a:xfrm rot="16200000">
              <a:off x="7785750" y="2527961"/>
              <a:ext cx="2406281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nti-Puromycin Ab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DE16BF7B-89B6-59F5-C2F4-560983EF3BB7}"/>
                </a:ext>
              </a:extLst>
            </p:cNvPr>
            <p:cNvSpPr txBox="1"/>
            <p:nvPr/>
          </p:nvSpPr>
          <p:spPr>
            <a:xfrm rot="16200000">
              <a:off x="8287262" y="5169836"/>
              <a:ext cx="142160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sz="2400" dirty="0">
                  <a:latin typeface="Aptos" panose="020B0004020202020204" pitchFamily="34" charset="0"/>
                </a:rPr>
                <a:t>α</a:t>
              </a:r>
              <a:r>
                <a:rPr lang="en-US" sz="2400" dirty="0">
                  <a:latin typeface="Aptos" panose="020B0004020202020204" pitchFamily="34" charset="0"/>
                </a:rPr>
                <a:t>-</a:t>
              </a:r>
              <a:r>
                <a:rPr lang="en-US" sz="2400" dirty="0"/>
                <a:t>Tubulin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FA5616B-EC93-75C0-EBC8-3E7C8C9C4EF3}"/>
                </a:ext>
              </a:extLst>
            </p:cNvPr>
            <p:cNvSpPr txBox="1"/>
            <p:nvPr/>
          </p:nvSpPr>
          <p:spPr>
            <a:xfrm>
              <a:off x="7082215" y="426076"/>
              <a:ext cx="68416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JPEG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85F440F-6F34-7A78-840C-7337AC358C65}"/>
                </a:ext>
              </a:extLst>
            </p:cNvPr>
            <p:cNvSpPr txBox="1"/>
            <p:nvPr/>
          </p:nvSpPr>
          <p:spPr>
            <a:xfrm>
              <a:off x="9826391" y="419481"/>
              <a:ext cx="59824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TIFF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3C77B492-41AF-F741-EFB1-EAC6F6628C1C}"/>
                </a:ext>
              </a:extLst>
            </p:cNvPr>
            <p:cNvSpPr/>
            <p:nvPr/>
          </p:nvSpPr>
          <p:spPr>
            <a:xfrm>
              <a:off x="6352861" y="1713563"/>
              <a:ext cx="670036" cy="408100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FF03D50E-BAA8-08B7-0691-DF2CAF8F1590}"/>
                </a:ext>
              </a:extLst>
            </p:cNvPr>
            <p:cNvSpPr/>
            <p:nvPr/>
          </p:nvSpPr>
          <p:spPr>
            <a:xfrm>
              <a:off x="7023125" y="1713562"/>
              <a:ext cx="670036" cy="408100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2A452170-9113-5069-ED16-8223CA32B34F}"/>
                </a:ext>
              </a:extLst>
            </p:cNvPr>
            <p:cNvSpPr/>
            <p:nvPr/>
          </p:nvSpPr>
          <p:spPr>
            <a:xfrm>
              <a:off x="8015214" y="1695574"/>
              <a:ext cx="670036" cy="408100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AD1502A-FBD5-32B8-FC38-0F489F49D866}"/>
                </a:ext>
              </a:extLst>
            </p:cNvPr>
            <p:cNvSpPr/>
            <p:nvPr/>
          </p:nvSpPr>
          <p:spPr>
            <a:xfrm>
              <a:off x="9349152" y="1762273"/>
              <a:ext cx="670036" cy="408100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6F07D0D8-110C-12E3-F670-D143C7786484}"/>
                </a:ext>
              </a:extLst>
            </p:cNvPr>
            <p:cNvSpPr/>
            <p:nvPr/>
          </p:nvSpPr>
          <p:spPr>
            <a:xfrm>
              <a:off x="10077533" y="1758859"/>
              <a:ext cx="670036" cy="408100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289E840A-CA87-3687-09AA-C336516D72EF}"/>
                </a:ext>
              </a:extLst>
            </p:cNvPr>
            <p:cNvSpPr/>
            <p:nvPr/>
          </p:nvSpPr>
          <p:spPr>
            <a:xfrm>
              <a:off x="11087062" y="1758858"/>
              <a:ext cx="729844" cy="408100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C89B26B7-F742-0609-39F6-F4CFAC63C621}"/>
                </a:ext>
              </a:extLst>
            </p:cNvPr>
            <p:cNvGrpSpPr/>
            <p:nvPr/>
          </p:nvGrpSpPr>
          <p:grpSpPr>
            <a:xfrm>
              <a:off x="5061497" y="4409280"/>
              <a:ext cx="908199" cy="2108626"/>
              <a:chOff x="4353659" y="4399354"/>
              <a:chExt cx="908199" cy="2296485"/>
            </a:xfrm>
          </p:grpSpPr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id="{9FD52B3C-FE5C-2A91-CC18-42F06A91A70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0314" y="4596237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1AF0440-D7EC-B086-4542-80A086C5D2F9}"/>
                  </a:ext>
                </a:extLst>
              </p:cNvPr>
              <p:cNvSpPr txBox="1"/>
              <p:nvPr/>
            </p:nvSpPr>
            <p:spPr>
              <a:xfrm>
                <a:off x="4353659" y="4399354"/>
                <a:ext cx="711668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250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39" name="Straight Connector 38">
                <a:extLst>
                  <a:ext uri="{FF2B5EF4-FFF2-40B4-BE49-F238E27FC236}">
                    <a16:creationId xmlns:a16="http://schemas.microsoft.com/office/drawing/2014/main" id="{F67C3A27-38C2-8B95-E008-176E3A2A3E9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0003" y="4756781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71B357C9-A322-28B4-C014-66B84EA19BA7}"/>
                  </a:ext>
                </a:extLst>
              </p:cNvPr>
              <p:cNvSpPr txBox="1"/>
              <p:nvPr/>
            </p:nvSpPr>
            <p:spPr>
              <a:xfrm>
                <a:off x="4359479" y="4591331"/>
                <a:ext cx="711668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130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8243D9E1-AAE3-4853-3102-43C16FAC1FC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32885" y="4944322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C126FC23-74EB-6D54-19A4-A05B66C6022B}"/>
                  </a:ext>
                </a:extLst>
              </p:cNvPr>
              <p:cNvSpPr txBox="1"/>
              <p:nvPr/>
            </p:nvSpPr>
            <p:spPr>
              <a:xfrm>
                <a:off x="4365918" y="4778872"/>
                <a:ext cx="711668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100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83C88D1E-C398-95E0-99EF-9A411A7758D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33052" y="5126765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00D3D74D-05B4-0B69-4951-0EE16CECD3EE}"/>
                  </a:ext>
                </a:extLst>
              </p:cNvPr>
              <p:cNvSpPr txBox="1"/>
              <p:nvPr/>
            </p:nvSpPr>
            <p:spPr>
              <a:xfrm>
                <a:off x="4465521" y="4961125"/>
                <a:ext cx="629407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70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AE64388B-4ACD-8A6E-6947-C22207A48C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40096" y="5362153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37B0175F-EC3F-7DD9-DBC3-E3EDAFE957AB}"/>
                  </a:ext>
                </a:extLst>
              </p:cNvPr>
              <p:cNvSpPr txBox="1"/>
              <p:nvPr/>
            </p:nvSpPr>
            <p:spPr>
              <a:xfrm>
                <a:off x="4472056" y="5208729"/>
                <a:ext cx="629407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5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58" name="Straight Connector 57">
                <a:extLst>
                  <a:ext uri="{FF2B5EF4-FFF2-40B4-BE49-F238E27FC236}">
                    <a16:creationId xmlns:a16="http://schemas.microsoft.com/office/drawing/2014/main" id="{430BBB70-B64D-51F1-F5B6-D26C76B505A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5961" y="5805470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46337F30-F7F5-C74D-EB38-E2869A8F2BCE}"/>
                  </a:ext>
                </a:extLst>
              </p:cNvPr>
              <p:cNvSpPr txBox="1"/>
              <p:nvPr/>
            </p:nvSpPr>
            <p:spPr>
              <a:xfrm>
                <a:off x="4483392" y="5653178"/>
                <a:ext cx="629407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3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60" name="Straight Connector 59">
                <a:extLst>
                  <a:ext uri="{FF2B5EF4-FFF2-40B4-BE49-F238E27FC236}">
                    <a16:creationId xmlns:a16="http://schemas.microsoft.com/office/drawing/2014/main" id="{C0A726A1-4ACD-CEF0-6F44-DE978CB04EB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7789" y="6160421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70547A0F-7474-34DC-09F6-28C61E061362}"/>
                  </a:ext>
                </a:extLst>
              </p:cNvPr>
              <p:cNvSpPr txBox="1"/>
              <p:nvPr/>
            </p:nvSpPr>
            <p:spPr>
              <a:xfrm>
                <a:off x="4472152" y="6009788"/>
                <a:ext cx="629407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2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  <p:cxnSp>
            <p:nvCxnSpPr>
              <p:cNvPr id="62" name="Straight Connector 61">
                <a:extLst>
                  <a:ext uri="{FF2B5EF4-FFF2-40B4-BE49-F238E27FC236}">
                    <a16:creationId xmlns:a16="http://schemas.microsoft.com/office/drawing/2014/main" id="{38926DAB-C795-0B1F-5274-83FC2881DF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44548" y="6603209"/>
                <a:ext cx="117310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TextBox 62">
                <a:extLst>
                  <a:ext uri="{FF2B5EF4-FFF2-40B4-BE49-F238E27FC236}">
                    <a16:creationId xmlns:a16="http://schemas.microsoft.com/office/drawing/2014/main" id="{4DE888D3-E758-A3C0-DB4A-A3C79A004EC5}"/>
                  </a:ext>
                </a:extLst>
              </p:cNvPr>
              <p:cNvSpPr txBox="1"/>
              <p:nvPr/>
            </p:nvSpPr>
            <p:spPr>
              <a:xfrm>
                <a:off x="4475907" y="6432012"/>
                <a:ext cx="629407" cy="26382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15 </a:t>
                </a:r>
                <a:r>
                  <a:rPr lang="en-US" sz="1400" dirty="0" err="1"/>
                  <a:t>KDa</a:t>
                </a:r>
                <a:endParaRPr lang="en-US" sz="14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2662375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4" name="Group 103">
            <a:extLst>
              <a:ext uri="{FF2B5EF4-FFF2-40B4-BE49-F238E27FC236}">
                <a16:creationId xmlns:a16="http://schemas.microsoft.com/office/drawing/2014/main" id="{8F9EFB82-93BB-E387-4EB0-C3DE04E26860}"/>
              </a:ext>
            </a:extLst>
          </p:cNvPr>
          <p:cNvGrpSpPr/>
          <p:nvPr/>
        </p:nvGrpSpPr>
        <p:grpSpPr>
          <a:xfrm>
            <a:off x="8225618" y="0"/>
            <a:ext cx="4007996" cy="3416344"/>
            <a:chOff x="8346805" y="-23912"/>
            <a:chExt cx="4007996" cy="3707506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9114125-86A8-8420-8F66-E1303617FC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63" t="57319" r="-1303" b="9226"/>
            <a:stretch>
              <a:fillRect/>
            </a:stretch>
          </p:blipFill>
          <p:spPr>
            <a:xfrm>
              <a:off x="8709492" y="2311994"/>
              <a:ext cx="3028719" cy="13716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98F3703D-D603-4910-B416-685EFA1437F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2" t="52297" r="1127" b="11200"/>
            <a:stretch>
              <a:fillRect/>
            </a:stretch>
          </p:blipFill>
          <p:spPr>
            <a:xfrm>
              <a:off x="8709492" y="779271"/>
              <a:ext cx="3028719" cy="1496707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9C31B00-1EF4-308B-2E3C-B1CB63CD4ACF}"/>
                </a:ext>
              </a:extLst>
            </p:cNvPr>
            <p:cNvSpPr txBox="1"/>
            <p:nvPr/>
          </p:nvSpPr>
          <p:spPr>
            <a:xfrm rot="16200000">
              <a:off x="8041593" y="2860952"/>
              <a:ext cx="97975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4EBP-1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43724DA-F9C5-E0CA-40FB-36AB2AB67D37}"/>
                </a:ext>
              </a:extLst>
            </p:cNvPr>
            <p:cNvSpPr txBox="1"/>
            <p:nvPr/>
          </p:nvSpPr>
          <p:spPr>
            <a:xfrm rot="16200000">
              <a:off x="7878049" y="1352321"/>
              <a:ext cx="13131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h-4EBP-1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432C074-803F-A213-B4D8-95450F69525C}"/>
                </a:ext>
              </a:extLst>
            </p:cNvPr>
            <p:cNvSpPr txBox="1"/>
            <p:nvPr/>
          </p:nvSpPr>
          <p:spPr>
            <a:xfrm>
              <a:off x="11807074" y="1302715"/>
              <a:ext cx="54528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64324FB-4608-291A-67D3-98759347F335}"/>
                </a:ext>
              </a:extLst>
            </p:cNvPr>
            <p:cNvSpPr txBox="1"/>
            <p:nvPr/>
          </p:nvSpPr>
          <p:spPr>
            <a:xfrm>
              <a:off x="11642084" y="1217067"/>
              <a:ext cx="372146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D613A4D-F56D-495C-4E88-B3922B342496}"/>
                </a:ext>
              </a:extLst>
            </p:cNvPr>
            <p:cNvSpPr txBox="1"/>
            <p:nvPr/>
          </p:nvSpPr>
          <p:spPr>
            <a:xfrm>
              <a:off x="11809513" y="2713997"/>
              <a:ext cx="54528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7358BC3-C97F-28C5-B5E4-FEEA9AFF6445}"/>
                </a:ext>
              </a:extLst>
            </p:cNvPr>
            <p:cNvSpPr txBox="1"/>
            <p:nvPr/>
          </p:nvSpPr>
          <p:spPr>
            <a:xfrm>
              <a:off x="11586189" y="2638576"/>
              <a:ext cx="372146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89AC9AB4-3437-A071-8878-328888F57524}"/>
                </a:ext>
              </a:extLst>
            </p:cNvPr>
            <p:cNvSpPr txBox="1"/>
            <p:nvPr/>
          </p:nvSpPr>
          <p:spPr>
            <a:xfrm>
              <a:off x="9560592" y="-23912"/>
              <a:ext cx="13845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SUM159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6A804739-DCF1-DF75-D910-1CB866C32D61}"/>
                </a:ext>
              </a:extLst>
            </p:cNvPr>
            <p:cNvSpPr txBox="1"/>
            <p:nvPr/>
          </p:nvSpPr>
          <p:spPr>
            <a:xfrm rot="18754354">
              <a:off x="9890504" y="354887"/>
              <a:ext cx="52770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F34B20E5-958E-A364-2B77-9CF3285A694C}"/>
                </a:ext>
              </a:extLst>
            </p:cNvPr>
            <p:cNvSpPr txBox="1"/>
            <p:nvPr/>
          </p:nvSpPr>
          <p:spPr>
            <a:xfrm rot="18754354">
              <a:off x="10252001" y="347571"/>
              <a:ext cx="5421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solidFill>
                    <a:srgbClr val="00206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</a:t>
              </a:r>
            </a:p>
          </p:txBody>
        </p:sp>
        <p:cxnSp>
          <p:nvCxnSpPr>
            <p:cNvPr id="76" name="Straight Connector 75">
              <a:extLst>
                <a:ext uri="{FF2B5EF4-FFF2-40B4-BE49-F238E27FC236}">
                  <a16:creationId xmlns:a16="http://schemas.microsoft.com/office/drawing/2014/main" id="{940CAE4B-3E9D-4831-C71C-3A8C3AA79A82}"/>
                </a:ext>
              </a:extLst>
            </p:cNvPr>
            <p:cNvCxnSpPr/>
            <p:nvPr/>
          </p:nvCxnSpPr>
          <p:spPr>
            <a:xfrm flipH="1">
              <a:off x="9828530" y="311136"/>
              <a:ext cx="822960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058DF909-820B-EDB4-9C72-09159BEFEB4A}"/>
                </a:ext>
              </a:extLst>
            </p:cNvPr>
            <p:cNvSpPr/>
            <p:nvPr/>
          </p:nvSpPr>
          <p:spPr>
            <a:xfrm>
              <a:off x="9838031" y="857874"/>
              <a:ext cx="758374" cy="2681573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0" name="Group 89">
            <a:extLst>
              <a:ext uri="{FF2B5EF4-FFF2-40B4-BE49-F238E27FC236}">
                <a16:creationId xmlns:a16="http://schemas.microsoft.com/office/drawing/2014/main" id="{3A670194-9B1A-AEAF-FF0B-02F49AA551A3}"/>
              </a:ext>
            </a:extLst>
          </p:cNvPr>
          <p:cNvGrpSpPr/>
          <p:nvPr/>
        </p:nvGrpSpPr>
        <p:grpSpPr>
          <a:xfrm>
            <a:off x="-14419" y="738995"/>
            <a:ext cx="4018688" cy="5434642"/>
            <a:chOff x="96614" y="33916"/>
            <a:chExt cx="4018688" cy="5434642"/>
          </a:xfrm>
        </p:grpSpPr>
        <p:grpSp>
          <p:nvGrpSpPr>
            <p:cNvPr id="83" name="Group 82">
              <a:extLst>
                <a:ext uri="{FF2B5EF4-FFF2-40B4-BE49-F238E27FC236}">
                  <a16:creationId xmlns:a16="http://schemas.microsoft.com/office/drawing/2014/main" id="{3C72775C-4830-6B55-5730-92B9190B0459}"/>
                </a:ext>
              </a:extLst>
            </p:cNvPr>
            <p:cNvGrpSpPr/>
            <p:nvPr/>
          </p:nvGrpSpPr>
          <p:grpSpPr>
            <a:xfrm>
              <a:off x="96614" y="33916"/>
              <a:ext cx="4018688" cy="5368541"/>
              <a:chOff x="65012" y="939195"/>
              <a:chExt cx="4018688" cy="5368541"/>
            </a:xfrm>
          </p:grpSpPr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F4DED4B5-0696-60AA-C945-E749C06DC5AC}"/>
                  </a:ext>
                </a:extLst>
              </p:cNvPr>
              <p:cNvGrpSpPr/>
              <p:nvPr/>
            </p:nvGrpSpPr>
            <p:grpSpPr>
              <a:xfrm>
                <a:off x="65012" y="1691413"/>
                <a:ext cx="4018688" cy="4616323"/>
                <a:chOff x="65012" y="897325"/>
                <a:chExt cx="4018688" cy="4616323"/>
              </a:xfrm>
            </p:grpSpPr>
            <p:grpSp>
              <p:nvGrpSpPr>
                <p:cNvPr id="51" name="Group 50">
                  <a:extLst>
                    <a:ext uri="{FF2B5EF4-FFF2-40B4-BE49-F238E27FC236}">
                      <a16:creationId xmlns:a16="http://schemas.microsoft.com/office/drawing/2014/main" id="{C7EB667C-A10D-D05A-BFE1-48493C7289E6}"/>
                    </a:ext>
                  </a:extLst>
                </p:cNvPr>
                <p:cNvGrpSpPr/>
                <p:nvPr/>
              </p:nvGrpSpPr>
              <p:grpSpPr>
                <a:xfrm>
                  <a:off x="65012" y="897325"/>
                  <a:ext cx="4018688" cy="4616323"/>
                  <a:chOff x="65012" y="897325"/>
                  <a:chExt cx="4018688" cy="4616323"/>
                </a:xfrm>
              </p:grpSpPr>
              <p:grpSp>
                <p:nvGrpSpPr>
                  <p:cNvPr id="48" name="Group 47">
                    <a:extLst>
                      <a:ext uri="{FF2B5EF4-FFF2-40B4-BE49-F238E27FC236}">
                        <a16:creationId xmlns:a16="http://schemas.microsoft.com/office/drawing/2014/main" id="{F1997480-B124-8DD7-5DC7-135BFB0FC797}"/>
                      </a:ext>
                    </a:extLst>
                  </p:cNvPr>
                  <p:cNvGrpSpPr/>
                  <p:nvPr/>
                </p:nvGrpSpPr>
                <p:grpSpPr>
                  <a:xfrm>
                    <a:off x="65012" y="897325"/>
                    <a:ext cx="3866464" cy="2282964"/>
                    <a:chOff x="-402352" y="647601"/>
                    <a:chExt cx="3866464" cy="2282964"/>
                  </a:xfrm>
                </p:grpSpPr>
                <p:pic>
                  <p:nvPicPr>
                    <p:cNvPr id="4" name="Picture 3">
                      <a:extLst>
                        <a:ext uri="{FF2B5EF4-FFF2-40B4-BE49-F238E27FC236}">
                          <a16:creationId xmlns:a16="http://schemas.microsoft.com/office/drawing/2014/main" id="{09254E0E-E273-E0FD-CFAE-7024852BA6B9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1587" t="28922" r="3108" b="13543"/>
                    <a:stretch>
                      <a:fillRect/>
                    </a:stretch>
                  </p:blipFill>
                  <p:spPr>
                    <a:xfrm>
                      <a:off x="-43043" y="647601"/>
                      <a:ext cx="2936643" cy="2282964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5" name="TextBox 14">
                      <a:extLst>
                        <a:ext uri="{FF2B5EF4-FFF2-40B4-BE49-F238E27FC236}">
                          <a16:creationId xmlns:a16="http://schemas.microsoft.com/office/drawing/2014/main" id="{64EABB72-A2F8-EAE3-2C5A-C09299CB556F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681916" y="1289262"/>
                      <a:ext cx="928459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F4A1</a:t>
                      </a:r>
                    </a:p>
                  </p:txBody>
                </p:sp>
                <p:sp>
                  <p:nvSpPr>
                    <p:cNvPr id="22" name="TextBox 21">
                      <a:extLst>
                        <a:ext uri="{FF2B5EF4-FFF2-40B4-BE49-F238E27FC236}">
                          <a16:creationId xmlns:a16="http://schemas.microsoft.com/office/drawing/2014/main" id="{8B6AA742-7644-4F56-4156-E684E0D6819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18824" y="1061137"/>
                      <a:ext cx="545288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</a:p>
                    <a:p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47" name="Group 46">
                    <a:extLst>
                      <a:ext uri="{FF2B5EF4-FFF2-40B4-BE49-F238E27FC236}">
                        <a16:creationId xmlns:a16="http://schemas.microsoft.com/office/drawing/2014/main" id="{7422CE6B-60B8-DBE1-7382-71D4123C08A1}"/>
                      </a:ext>
                    </a:extLst>
                  </p:cNvPr>
                  <p:cNvGrpSpPr/>
                  <p:nvPr/>
                </p:nvGrpSpPr>
                <p:grpSpPr>
                  <a:xfrm>
                    <a:off x="69391" y="3096867"/>
                    <a:ext cx="4011451" cy="1193468"/>
                    <a:chOff x="-1171411" y="2640444"/>
                    <a:chExt cx="3901287" cy="1193468"/>
                  </a:xfrm>
                </p:grpSpPr>
                <p:pic>
                  <p:nvPicPr>
                    <p:cNvPr id="5" name="Picture 4" descr="A close-up of a white rectangular object&#10;&#10;AI-generated content may be incorrect.">
                      <a:extLst>
                        <a:ext uri="{FF2B5EF4-FFF2-40B4-BE49-F238E27FC236}">
                          <a16:creationId xmlns:a16="http://schemas.microsoft.com/office/drawing/2014/main" id="{5AD1E3D1-884B-7A82-50BF-18E8BAD214A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2479" t="73874" r="1117" b="12897"/>
                    <a:stretch>
                      <a:fillRect/>
                    </a:stretch>
                  </p:blipFill>
                  <p:spPr>
                    <a:xfrm>
                      <a:off x="-837928" y="2878592"/>
                      <a:ext cx="2973415" cy="74312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4" name="TextBox 13">
                      <a:extLst>
                        <a:ext uri="{FF2B5EF4-FFF2-40B4-BE49-F238E27FC236}">
                          <a16:creationId xmlns:a16="http://schemas.microsoft.com/office/drawing/2014/main" id="{912D7DFD-8471-F1F0-C1A9-5ED619CC56D2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1588550" y="3057583"/>
                      <a:ext cx="1193468" cy="35918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MT112</a:t>
                      </a:r>
                    </a:p>
                  </p:txBody>
                </p:sp>
                <p:sp>
                  <p:nvSpPr>
                    <p:cNvPr id="24" name="TextBox 23">
                      <a:extLst>
                        <a:ext uri="{FF2B5EF4-FFF2-40B4-BE49-F238E27FC236}">
                          <a16:creationId xmlns:a16="http://schemas.microsoft.com/office/drawing/2014/main" id="{8C02E7C6-2C3D-894E-F1C4-52563387C15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184588" y="2946820"/>
                      <a:ext cx="545288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  <a:p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5" name="TextBox 24">
                      <a:extLst>
                        <a:ext uri="{FF2B5EF4-FFF2-40B4-BE49-F238E27FC236}">
                          <a16:creationId xmlns:a16="http://schemas.microsoft.com/office/drawing/2014/main" id="{24998FA3-21E9-BBA0-AF44-9E53E71CE48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49816" y="2860766"/>
                      <a:ext cx="372146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3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grpSp>
                <p:nvGrpSpPr>
                  <p:cNvPr id="46" name="Group 45">
                    <a:extLst>
                      <a:ext uri="{FF2B5EF4-FFF2-40B4-BE49-F238E27FC236}">
                        <a16:creationId xmlns:a16="http://schemas.microsoft.com/office/drawing/2014/main" id="{E8D1E48F-DB4C-5CAB-455A-23EDD1F4D86E}"/>
                      </a:ext>
                    </a:extLst>
                  </p:cNvPr>
                  <p:cNvGrpSpPr/>
                  <p:nvPr/>
                </p:nvGrpSpPr>
                <p:grpSpPr>
                  <a:xfrm>
                    <a:off x="103066" y="4291306"/>
                    <a:ext cx="3980634" cy="1222342"/>
                    <a:chOff x="-1372378" y="4714483"/>
                    <a:chExt cx="3980634" cy="1222342"/>
                  </a:xfrm>
                </p:grpSpPr>
                <p:pic>
                  <p:nvPicPr>
                    <p:cNvPr id="3" name="Picture 2">
                      <a:extLst>
                        <a:ext uri="{FF2B5EF4-FFF2-40B4-BE49-F238E27FC236}">
                          <a16:creationId xmlns:a16="http://schemas.microsoft.com/office/drawing/2014/main" id="{EFB73179-6FD1-693D-78B7-523046C7188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1374" t="61430" r="7747" b="8758"/>
                    <a:stretch>
                      <a:fillRect/>
                    </a:stretch>
                  </p:blipFill>
                  <p:spPr>
                    <a:xfrm>
                      <a:off x="-1012559" y="4714483"/>
                      <a:ext cx="2923304" cy="122234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EBE3634F-056C-57F7-85CF-8DB3D8819C14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-1759055" y="5119722"/>
                      <a:ext cx="114268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l-GR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α</a:t>
                      </a:r>
                      <a:r>
                        <a:rPr lang="en-US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Tubulin</a:t>
                      </a:r>
                    </a:p>
                  </p:txBody>
                </p:sp>
                <p:sp>
                  <p:nvSpPr>
                    <p:cNvPr id="26" name="TextBox 25">
                      <a:extLst>
                        <a:ext uri="{FF2B5EF4-FFF2-40B4-BE49-F238E27FC236}">
                          <a16:creationId xmlns:a16="http://schemas.microsoft.com/office/drawing/2014/main" id="{EA6B8448-CDED-2443-70CB-2C1B463FFA8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2968" y="5098055"/>
                      <a:ext cx="545288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  <a:p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27" name="TextBox 26">
                      <a:extLst>
                        <a:ext uri="{FF2B5EF4-FFF2-40B4-BE49-F238E27FC236}">
                          <a16:creationId xmlns:a16="http://schemas.microsoft.com/office/drawing/2014/main" id="{2816085A-13C7-418C-4599-881C1179DC9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848818" y="5012001"/>
                      <a:ext cx="372146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3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BC7E1FF7-5E09-E076-8495-147225A015C3}"/>
                    </a:ext>
                  </a:extLst>
                </p:cNvPr>
                <p:cNvSpPr txBox="1"/>
                <p:nvPr/>
              </p:nvSpPr>
              <p:spPr>
                <a:xfrm>
                  <a:off x="3174891" y="1257316"/>
                  <a:ext cx="372146" cy="584775"/>
                </a:xfrm>
                <a:prstGeom prst="rect">
                  <a:avLst/>
                </a:prstGeom>
                <a:noFill/>
              </p:spPr>
              <p:txBody>
                <a:bodyPr wrap="square">
                  <a:spAutoFit/>
                </a:bodyPr>
                <a:lstStyle/>
                <a:p>
                  <a:r>
                    <a:rPr lang="en-US" sz="32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endParaRPr lang="en-US" sz="14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5" name="TextBox 64">
                <a:extLst>
                  <a:ext uri="{FF2B5EF4-FFF2-40B4-BE49-F238E27FC236}">
                    <a16:creationId xmlns:a16="http://schemas.microsoft.com/office/drawing/2014/main" id="{3CBDBEA5-75E5-CFB5-8843-2636A256AA98}"/>
                  </a:ext>
                </a:extLst>
              </p:cNvPr>
              <p:cNvSpPr txBox="1"/>
              <p:nvPr/>
            </p:nvSpPr>
            <p:spPr>
              <a:xfrm>
                <a:off x="1285389" y="939195"/>
                <a:ext cx="13845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UM159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11D8C44D-3494-16D9-7E06-CC06391BA115}"/>
                  </a:ext>
                </a:extLst>
              </p:cNvPr>
              <p:cNvSpPr txBox="1"/>
              <p:nvPr/>
            </p:nvSpPr>
            <p:spPr>
              <a:xfrm rot="18754354">
                <a:off x="1615301" y="1294082"/>
                <a:ext cx="52770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</a:p>
            </p:txBody>
          </p:sp>
          <p:sp>
            <p:nvSpPr>
              <p:cNvPr id="67" name="TextBox 66">
                <a:extLst>
                  <a:ext uri="{FF2B5EF4-FFF2-40B4-BE49-F238E27FC236}">
                    <a16:creationId xmlns:a16="http://schemas.microsoft.com/office/drawing/2014/main" id="{EAB31D4A-10FD-ECB7-324F-E6015B3A9324}"/>
                  </a:ext>
                </a:extLst>
              </p:cNvPr>
              <p:cNvSpPr txBox="1"/>
              <p:nvPr/>
            </p:nvSpPr>
            <p:spPr>
              <a:xfrm rot="18754354">
                <a:off x="1976798" y="1286766"/>
                <a:ext cx="54213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00206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D</a:t>
                </a:r>
              </a:p>
            </p:txBody>
          </p:sp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B3CB6DA6-E81E-9FB2-5279-05735D3463E7}"/>
                  </a:ext>
                </a:extLst>
              </p:cNvPr>
              <p:cNvCxnSpPr/>
              <p:nvPr/>
            </p:nvCxnSpPr>
            <p:spPr>
              <a:xfrm flipH="1">
                <a:off x="1553327" y="1286199"/>
                <a:ext cx="822960" cy="0"/>
              </a:xfrm>
              <a:prstGeom prst="line">
                <a:avLst/>
              </a:prstGeom>
              <a:ln w="28575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69" name="TextBox 68">
                <a:extLst>
                  <a:ext uri="{FF2B5EF4-FFF2-40B4-BE49-F238E27FC236}">
                    <a16:creationId xmlns:a16="http://schemas.microsoft.com/office/drawing/2014/main" id="{6EA5E1A2-835B-FA04-D4CE-08EA2F7E05F7}"/>
                  </a:ext>
                </a:extLst>
              </p:cNvPr>
              <p:cNvSpPr txBox="1"/>
              <p:nvPr/>
            </p:nvSpPr>
            <p:spPr>
              <a:xfrm>
                <a:off x="319135" y="939195"/>
                <a:ext cx="138456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T549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82805871-BD96-07AA-039D-AA585B5592A4}"/>
                  </a:ext>
                </a:extLst>
              </p:cNvPr>
              <p:cNvSpPr txBox="1"/>
              <p:nvPr/>
            </p:nvSpPr>
            <p:spPr>
              <a:xfrm rot="18754354">
                <a:off x="611466" y="1309613"/>
                <a:ext cx="52770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</a:p>
            </p:txBody>
          </p:sp>
          <p:sp>
            <p:nvSpPr>
              <p:cNvPr id="71" name="TextBox 70">
                <a:extLst>
                  <a:ext uri="{FF2B5EF4-FFF2-40B4-BE49-F238E27FC236}">
                    <a16:creationId xmlns:a16="http://schemas.microsoft.com/office/drawing/2014/main" id="{4CDB15AD-37DA-34FB-DD99-13DE8FA5A65C}"/>
                  </a:ext>
                </a:extLst>
              </p:cNvPr>
              <p:cNvSpPr txBox="1"/>
              <p:nvPr/>
            </p:nvSpPr>
            <p:spPr>
              <a:xfrm rot="18754354">
                <a:off x="966551" y="1302297"/>
                <a:ext cx="55496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E</a:t>
                </a:r>
              </a:p>
            </p:txBody>
          </p:sp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09196C06-B1DB-ED6A-4BC3-CE063F82746C}"/>
                  </a:ext>
                </a:extLst>
              </p:cNvPr>
              <p:cNvCxnSpPr/>
              <p:nvPr/>
            </p:nvCxnSpPr>
            <p:spPr>
              <a:xfrm flipH="1">
                <a:off x="614175" y="1289970"/>
                <a:ext cx="822960" cy="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8" name="Rectangle 87">
              <a:extLst>
                <a:ext uri="{FF2B5EF4-FFF2-40B4-BE49-F238E27FC236}">
                  <a16:creationId xmlns:a16="http://schemas.microsoft.com/office/drawing/2014/main" id="{1C7DE9E8-FDB2-BA45-0DB1-835FC19DE90D}"/>
                </a:ext>
              </a:extLst>
            </p:cNvPr>
            <p:cNvSpPr/>
            <p:nvPr/>
          </p:nvSpPr>
          <p:spPr>
            <a:xfrm>
              <a:off x="1682446" y="797521"/>
              <a:ext cx="651657" cy="467103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9" name="Rectangle 88">
              <a:extLst>
                <a:ext uri="{FF2B5EF4-FFF2-40B4-BE49-F238E27FC236}">
                  <a16:creationId xmlns:a16="http://schemas.microsoft.com/office/drawing/2014/main" id="{8CFC2640-37ED-D0B1-C38E-92D6EF4CD6D8}"/>
                </a:ext>
              </a:extLst>
            </p:cNvPr>
            <p:cNvSpPr/>
            <p:nvPr/>
          </p:nvSpPr>
          <p:spPr>
            <a:xfrm>
              <a:off x="745069" y="783739"/>
              <a:ext cx="651657" cy="4671037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3CE7629D-6FF9-2096-FDEB-18EDD3D16961}"/>
              </a:ext>
            </a:extLst>
          </p:cNvPr>
          <p:cNvGrpSpPr/>
          <p:nvPr/>
        </p:nvGrpSpPr>
        <p:grpSpPr>
          <a:xfrm>
            <a:off x="8263894" y="3479674"/>
            <a:ext cx="3931850" cy="3335652"/>
            <a:chOff x="8375175" y="3260594"/>
            <a:chExt cx="3931850" cy="3556715"/>
          </a:xfrm>
        </p:grpSpPr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E22173BD-63DD-3D01-6E67-0E4A77DA7F84}"/>
                </a:ext>
              </a:extLst>
            </p:cNvPr>
            <p:cNvSpPr txBox="1"/>
            <p:nvPr/>
          </p:nvSpPr>
          <p:spPr>
            <a:xfrm>
              <a:off x="8697344" y="3260594"/>
              <a:ext cx="138456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BT549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FE81B69D-B843-C359-B5F1-C2C325B09DFA}"/>
                </a:ext>
              </a:extLst>
            </p:cNvPr>
            <p:cNvSpPr txBox="1"/>
            <p:nvPr/>
          </p:nvSpPr>
          <p:spPr>
            <a:xfrm rot="18754354">
              <a:off x="8989675" y="3666253"/>
              <a:ext cx="52770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EV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B5139C74-DFCF-28D6-3E5F-8441D693D086}"/>
                </a:ext>
              </a:extLst>
            </p:cNvPr>
            <p:cNvSpPr txBox="1"/>
            <p:nvPr/>
          </p:nvSpPr>
          <p:spPr>
            <a:xfrm rot="18754354">
              <a:off x="9344760" y="3658937"/>
              <a:ext cx="55496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</a:p>
          </p:txBody>
        </p:sp>
        <p:cxnSp>
          <p:nvCxnSpPr>
            <p:cNvPr id="80" name="Straight Connector 79">
              <a:extLst>
                <a:ext uri="{FF2B5EF4-FFF2-40B4-BE49-F238E27FC236}">
                  <a16:creationId xmlns:a16="http://schemas.microsoft.com/office/drawing/2014/main" id="{E9DD1323-98E4-863E-5A8D-20136120F7D6}"/>
                </a:ext>
              </a:extLst>
            </p:cNvPr>
            <p:cNvCxnSpPr/>
            <p:nvPr/>
          </p:nvCxnSpPr>
          <p:spPr>
            <a:xfrm flipH="1">
              <a:off x="8992384" y="3611369"/>
              <a:ext cx="822960" cy="0"/>
            </a:xfrm>
            <a:prstGeom prst="line">
              <a:avLst/>
            </a:prstGeom>
            <a:ln w="28575">
              <a:solidFill>
                <a:srgbClr val="C0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92" name="Picture 91">
              <a:extLst>
                <a:ext uri="{FF2B5EF4-FFF2-40B4-BE49-F238E27FC236}">
                  <a16:creationId xmlns:a16="http://schemas.microsoft.com/office/drawing/2014/main" id="{C5698744-15DF-2798-6926-A86957F0204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102" t="55816" r="8520" b="10329"/>
            <a:stretch>
              <a:fillRect/>
            </a:stretch>
          </p:blipFill>
          <p:spPr>
            <a:xfrm>
              <a:off x="8690171" y="5429185"/>
              <a:ext cx="2951913" cy="1388124"/>
            </a:xfrm>
            <a:prstGeom prst="rect">
              <a:avLst/>
            </a:prstGeom>
          </p:spPr>
        </p:pic>
        <p:pic>
          <p:nvPicPr>
            <p:cNvPr id="93" name="Picture 92">
              <a:extLst>
                <a:ext uri="{FF2B5EF4-FFF2-40B4-BE49-F238E27FC236}">
                  <a16:creationId xmlns:a16="http://schemas.microsoft.com/office/drawing/2014/main" id="{DB4EA8B6-8F51-3F22-84F3-A071A4A7C45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" t="58419" r="1752" b="9544"/>
            <a:stretch>
              <a:fillRect/>
            </a:stretch>
          </p:blipFill>
          <p:spPr>
            <a:xfrm>
              <a:off x="8746439" y="4010176"/>
              <a:ext cx="2923302" cy="1313619"/>
            </a:xfrm>
            <a:prstGeom prst="rect">
              <a:avLst/>
            </a:prstGeom>
          </p:spPr>
        </p:pic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3A277A59-A018-6B85-8EA4-D65C12ABC2F6}"/>
                </a:ext>
              </a:extLst>
            </p:cNvPr>
            <p:cNvSpPr txBox="1"/>
            <p:nvPr/>
          </p:nvSpPr>
          <p:spPr>
            <a:xfrm>
              <a:off x="11748085" y="4345896"/>
              <a:ext cx="54528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>
              <a:extLst>
                <a:ext uri="{FF2B5EF4-FFF2-40B4-BE49-F238E27FC236}">
                  <a16:creationId xmlns:a16="http://schemas.microsoft.com/office/drawing/2014/main" id="{F4FC820A-081A-0DF6-60B1-2E11654E9796}"/>
                </a:ext>
              </a:extLst>
            </p:cNvPr>
            <p:cNvSpPr txBox="1"/>
            <p:nvPr/>
          </p:nvSpPr>
          <p:spPr>
            <a:xfrm>
              <a:off x="11524761" y="4270475"/>
              <a:ext cx="372146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ACC49CB1-60BC-B9B3-BB43-39EA95FEC12E}"/>
                </a:ext>
              </a:extLst>
            </p:cNvPr>
            <p:cNvSpPr txBox="1"/>
            <p:nvPr/>
          </p:nvSpPr>
          <p:spPr>
            <a:xfrm>
              <a:off x="11761737" y="5745281"/>
              <a:ext cx="545288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  <a:p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4A5D3E5A-263E-BD9D-4817-55FDDD48EA3F}"/>
                </a:ext>
              </a:extLst>
            </p:cNvPr>
            <p:cNvSpPr txBox="1"/>
            <p:nvPr/>
          </p:nvSpPr>
          <p:spPr>
            <a:xfrm>
              <a:off x="11538413" y="5669860"/>
              <a:ext cx="372146" cy="58477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3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>
              <a:extLst>
                <a:ext uri="{FF2B5EF4-FFF2-40B4-BE49-F238E27FC236}">
                  <a16:creationId xmlns:a16="http://schemas.microsoft.com/office/drawing/2014/main" id="{B87F2670-9580-63D2-94DE-7152AF57CF70}"/>
                </a:ext>
              </a:extLst>
            </p:cNvPr>
            <p:cNvSpPr txBox="1"/>
            <p:nvPr/>
          </p:nvSpPr>
          <p:spPr>
            <a:xfrm rot="16200000">
              <a:off x="8077812" y="5960186"/>
              <a:ext cx="97975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4EBP-1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FED922E4-4852-D56C-4036-E98035EF7BCD}"/>
                </a:ext>
              </a:extLst>
            </p:cNvPr>
            <p:cNvSpPr txBox="1"/>
            <p:nvPr/>
          </p:nvSpPr>
          <p:spPr>
            <a:xfrm rot="16200000">
              <a:off x="7903251" y="4499379"/>
              <a:ext cx="13131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ph-4EBP-1</a:t>
              </a:r>
            </a:p>
          </p:txBody>
        </p:sp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C73994A6-CE98-E8DB-0613-8ABD341540DD}"/>
                </a:ext>
              </a:extLst>
            </p:cNvPr>
            <p:cNvSpPr/>
            <p:nvPr/>
          </p:nvSpPr>
          <p:spPr>
            <a:xfrm>
              <a:off x="8966077" y="4062228"/>
              <a:ext cx="851185" cy="2681573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  <a:prstDash val="dash"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2" name="Group 121">
            <a:extLst>
              <a:ext uri="{FF2B5EF4-FFF2-40B4-BE49-F238E27FC236}">
                <a16:creationId xmlns:a16="http://schemas.microsoft.com/office/drawing/2014/main" id="{641835CA-0799-108A-8F0E-7B42CCAD1D60}"/>
              </a:ext>
            </a:extLst>
          </p:cNvPr>
          <p:cNvGrpSpPr/>
          <p:nvPr/>
        </p:nvGrpSpPr>
        <p:grpSpPr>
          <a:xfrm>
            <a:off x="3960868" y="815004"/>
            <a:ext cx="4242677" cy="4380257"/>
            <a:chOff x="4073697" y="815004"/>
            <a:chExt cx="4242677" cy="4380257"/>
          </a:xfrm>
        </p:grpSpPr>
        <p:grpSp>
          <p:nvGrpSpPr>
            <p:cNvPr id="87" name="Group 86">
              <a:extLst>
                <a:ext uri="{FF2B5EF4-FFF2-40B4-BE49-F238E27FC236}">
                  <a16:creationId xmlns:a16="http://schemas.microsoft.com/office/drawing/2014/main" id="{542C2886-696F-7F3B-9623-D94FB8B1CFD0}"/>
                </a:ext>
              </a:extLst>
            </p:cNvPr>
            <p:cNvGrpSpPr/>
            <p:nvPr/>
          </p:nvGrpSpPr>
          <p:grpSpPr>
            <a:xfrm>
              <a:off x="4073697" y="815004"/>
              <a:ext cx="4013295" cy="4380257"/>
              <a:chOff x="4109349" y="836815"/>
              <a:chExt cx="4013295" cy="4380257"/>
            </a:xfrm>
          </p:grpSpPr>
          <p:grpSp>
            <p:nvGrpSpPr>
              <p:cNvPr id="82" name="Group 81">
                <a:extLst>
                  <a:ext uri="{FF2B5EF4-FFF2-40B4-BE49-F238E27FC236}">
                    <a16:creationId xmlns:a16="http://schemas.microsoft.com/office/drawing/2014/main" id="{A49BEE5A-5933-4584-7E5E-3473DF37C750}"/>
                  </a:ext>
                </a:extLst>
              </p:cNvPr>
              <p:cNvGrpSpPr/>
              <p:nvPr/>
            </p:nvGrpSpPr>
            <p:grpSpPr>
              <a:xfrm>
                <a:off x="4109349" y="836815"/>
                <a:ext cx="4013295" cy="4380257"/>
                <a:chOff x="4109349" y="836815"/>
                <a:chExt cx="4013295" cy="4380257"/>
              </a:xfrm>
            </p:grpSpPr>
            <p:sp>
              <p:nvSpPr>
                <p:cNvPr id="30" name="TextBox 29">
                  <a:extLst>
                    <a:ext uri="{FF2B5EF4-FFF2-40B4-BE49-F238E27FC236}">
                      <a16:creationId xmlns:a16="http://schemas.microsoft.com/office/drawing/2014/main" id="{86B17169-DB7D-5F99-F367-4FCE34FC4A06}"/>
                    </a:ext>
                  </a:extLst>
                </p:cNvPr>
                <p:cNvSpPr txBox="1"/>
                <p:nvPr/>
              </p:nvSpPr>
              <p:spPr>
                <a:xfrm>
                  <a:off x="5421959" y="836815"/>
                  <a:ext cx="138456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UM159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80986EC8-C665-05C7-CF9F-9B749B20F39A}"/>
                    </a:ext>
                  </a:extLst>
                </p:cNvPr>
                <p:cNvSpPr txBox="1"/>
                <p:nvPr/>
              </p:nvSpPr>
              <p:spPr>
                <a:xfrm rot="18754354">
                  <a:off x="5751871" y="1191702"/>
                  <a:ext cx="527709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V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E5283BE4-884C-CF3F-E331-1CEC84EB8AE8}"/>
                    </a:ext>
                  </a:extLst>
                </p:cNvPr>
                <p:cNvSpPr txBox="1"/>
                <p:nvPr/>
              </p:nvSpPr>
              <p:spPr>
                <a:xfrm rot="18754354">
                  <a:off x="6113368" y="1184386"/>
                  <a:ext cx="54213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00206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</a:p>
              </p:txBody>
            </p: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D4091FBE-353F-0C68-1ACB-F979C2FE47E3}"/>
                    </a:ext>
                  </a:extLst>
                </p:cNvPr>
                <p:cNvCxnSpPr/>
                <p:nvPr/>
              </p:nvCxnSpPr>
              <p:spPr>
                <a:xfrm flipH="1">
                  <a:off x="5689897" y="1183819"/>
                  <a:ext cx="822960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grpSp>
              <p:nvGrpSpPr>
                <p:cNvPr id="49" name="Group 48">
                  <a:extLst>
                    <a:ext uri="{FF2B5EF4-FFF2-40B4-BE49-F238E27FC236}">
                      <a16:creationId xmlns:a16="http://schemas.microsoft.com/office/drawing/2014/main" id="{343E14F2-C93A-437A-1062-2652451705EE}"/>
                    </a:ext>
                  </a:extLst>
                </p:cNvPr>
                <p:cNvGrpSpPr/>
                <p:nvPr/>
              </p:nvGrpSpPr>
              <p:grpSpPr>
                <a:xfrm>
                  <a:off x="4109349" y="1659669"/>
                  <a:ext cx="4013295" cy="3557403"/>
                  <a:chOff x="4162800" y="907733"/>
                  <a:chExt cx="4013295" cy="3557403"/>
                </a:xfrm>
              </p:grpSpPr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4648A292-A53F-918D-3381-9F45F77266F3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3793468" y="1320561"/>
                    <a:ext cx="1107996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h-eIF2a</a:t>
                    </a:r>
                  </a:p>
                </p:txBody>
              </p:sp>
              <p:sp>
                <p:nvSpPr>
                  <p:cNvPr id="20" name="TextBox 19">
                    <a:extLst>
                      <a:ext uri="{FF2B5EF4-FFF2-40B4-BE49-F238E27FC236}">
                        <a16:creationId xmlns:a16="http://schemas.microsoft.com/office/drawing/2014/main" id="{92379B48-AF49-D96C-C837-1BBE6DD9365E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4020248" y="3114446"/>
                    <a:ext cx="774571" cy="36933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IF2a</a:t>
                    </a:r>
                  </a:p>
                </p:txBody>
              </p:sp>
              <p:grpSp>
                <p:nvGrpSpPr>
                  <p:cNvPr id="45" name="Group 44">
                    <a:extLst>
                      <a:ext uri="{FF2B5EF4-FFF2-40B4-BE49-F238E27FC236}">
                        <a16:creationId xmlns:a16="http://schemas.microsoft.com/office/drawing/2014/main" id="{C0BDF1B2-272F-D2C2-8378-EF42DFE57FE8}"/>
                      </a:ext>
                    </a:extLst>
                  </p:cNvPr>
                  <p:cNvGrpSpPr/>
                  <p:nvPr/>
                </p:nvGrpSpPr>
                <p:grpSpPr>
                  <a:xfrm>
                    <a:off x="4476411" y="907733"/>
                    <a:ext cx="3699684" cy="1196135"/>
                    <a:chOff x="6386019" y="32777"/>
                    <a:chExt cx="3699684" cy="1196135"/>
                  </a:xfrm>
                </p:grpSpPr>
                <p:pic>
                  <p:nvPicPr>
                    <p:cNvPr id="10" name="Picture 9">
                      <a:extLst>
                        <a:ext uri="{FF2B5EF4-FFF2-40B4-BE49-F238E27FC236}">
                          <a16:creationId xmlns:a16="http://schemas.microsoft.com/office/drawing/2014/main" id="{BCB6927A-43E9-37F0-2C1C-19BAC678AB2B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1710" t="62197" r="-3426" b="11649"/>
                    <a:stretch>
                      <a:fillRect/>
                    </a:stretch>
                  </p:blipFill>
                  <p:spPr>
                    <a:xfrm>
                      <a:off x="6386019" y="32777"/>
                      <a:ext cx="3162021" cy="107236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C0CA23E6-8813-A88F-9DC5-95B051BDA15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540415" y="705692"/>
                      <a:ext cx="545288" cy="523220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8</a:t>
                      </a:r>
                    </a:p>
                    <a:p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37" name="TextBox 36">
                      <a:extLst>
                        <a:ext uri="{FF2B5EF4-FFF2-40B4-BE49-F238E27FC236}">
                          <a16:creationId xmlns:a16="http://schemas.microsoft.com/office/drawing/2014/main" id="{64310106-647E-AB7D-0D5C-15F1BEFF77E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317091" y="630271"/>
                      <a:ext cx="372146" cy="584775"/>
                    </a:xfrm>
                    <a:prstGeom prst="rect">
                      <a:avLst/>
                    </a:prstGeom>
                    <a:noFill/>
                  </p:spPr>
                  <p:txBody>
                    <a:bodyPr wrap="square">
                      <a:spAutoFit/>
                    </a:bodyPr>
                    <a:lstStyle/>
                    <a:p>
                      <a:r>
                        <a:rPr lang="en-US" sz="3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pic>
                <p:nvPicPr>
                  <p:cNvPr id="9" name="Picture 8">
                    <a:extLst>
                      <a:ext uri="{FF2B5EF4-FFF2-40B4-BE49-F238E27FC236}">
                        <a16:creationId xmlns:a16="http://schemas.microsoft.com/office/drawing/2014/main" id="{46947159-BF9A-D0BA-B30F-532CD53FBAD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-3945" t="32157" r="-2093" b="9218"/>
                  <a:stretch>
                    <a:fillRect/>
                  </a:stretch>
                </p:blipFill>
                <p:spPr>
                  <a:xfrm>
                    <a:off x="4476411" y="2061351"/>
                    <a:ext cx="3162020" cy="240378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4BB6362D-5FDB-44E7-A9F0-17966A7DF0C6}"/>
                    </a:ext>
                  </a:extLst>
                </p:cNvPr>
                <p:cNvSpPr txBox="1"/>
                <p:nvPr/>
              </p:nvSpPr>
              <p:spPr>
                <a:xfrm>
                  <a:off x="4455705" y="836815"/>
                  <a:ext cx="1384569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T549</a:t>
                  </a:r>
                </a:p>
              </p:txBody>
            </p:sp>
            <p:sp>
              <p:nvSpPr>
                <p:cNvPr id="54" name="TextBox 53">
                  <a:extLst>
                    <a:ext uri="{FF2B5EF4-FFF2-40B4-BE49-F238E27FC236}">
                      <a16:creationId xmlns:a16="http://schemas.microsoft.com/office/drawing/2014/main" id="{841CC6C8-B937-060E-365A-AD1928A95152}"/>
                    </a:ext>
                  </a:extLst>
                </p:cNvPr>
                <p:cNvSpPr txBox="1"/>
                <p:nvPr/>
              </p:nvSpPr>
              <p:spPr>
                <a:xfrm rot="18754354">
                  <a:off x="4748036" y="1207233"/>
                  <a:ext cx="527709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V</a:t>
                  </a:r>
                </a:p>
              </p:txBody>
            </p: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F3B7B051-8D4D-4D2D-06B9-E5E6313742D8}"/>
                    </a:ext>
                  </a:extLst>
                </p:cNvPr>
                <p:cNvSpPr txBox="1"/>
                <p:nvPr/>
              </p:nvSpPr>
              <p:spPr>
                <a:xfrm rot="18754354">
                  <a:off x="5103121" y="1199917"/>
                  <a:ext cx="554960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20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E</a:t>
                  </a:r>
                </a:p>
              </p:txBody>
            </p:sp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id="{AB39D1BB-9141-3A11-82BE-35EDFF9F46AA}"/>
                    </a:ext>
                  </a:extLst>
                </p:cNvPr>
                <p:cNvCxnSpPr/>
                <p:nvPr/>
              </p:nvCxnSpPr>
              <p:spPr>
                <a:xfrm flipH="1">
                  <a:off x="4750745" y="1187590"/>
                  <a:ext cx="822960" cy="0"/>
                </a:xfrm>
                <a:prstGeom prst="line">
                  <a:avLst/>
                </a:prstGeom>
                <a:ln w="28575">
                  <a:solidFill>
                    <a:srgbClr val="C00000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4" name="Rectangle 83">
                <a:extLst>
                  <a:ext uri="{FF2B5EF4-FFF2-40B4-BE49-F238E27FC236}">
                    <a16:creationId xmlns:a16="http://schemas.microsoft.com/office/drawing/2014/main" id="{4B4349BE-C75B-0307-0EE0-AD1307CC9DF3}"/>
                  </a:ext>
                </a:extLst>
              </p:cNvPr>
              <p:cNvSpPr/>
              <p:nvPr/>
            </p:nvSpPr>
            <p:spPr>
              <a:xfrm>
                <a:off x="4850705" y="1613964"/>
                <a:ext cx="651657" cy="3083852"/>
              </a:xfrm>
              <a:prstGeom prst="rect">
                <a:avLst/>
              </a:prstGeom>
              <a:noFill/>
              <a:ln>
                <a:solidFill>
                  <a:schemeClr val="tx1">
                    <a:lumMod val="65000"/>
                    <a:lumOff val="3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85" name="Rectangle 84">
                <a:extLst>
                  <a:ext uri="{FF2B5EF4-FFF2-40B4-BE49-F238E27FC236}">
                    <a16:creationId xmlns:a16="http://schemas.microsoft.com/office/drawing/2014/main" id="{583EFF04-51A9-9BFF-CB4F-4F70C1DEC9A2}"/>
                  </a:ext>
                </a:extLst>
              </p:cNvPr>
              <p:cNvSpPr/>
              <p:nvPr/>
            </p:nvSpPr>
            <p:spPr>
              <a:xfrm>
                <a:off x="5741257" y="1624196"/>
                <a:ext cx="651657" cy="3083852"/>
              </a:xfrm>
              <a:prstGeom prst="rect">
                <a:avLst/>
              </a:prstGeom>
              <a:noFill/>
              <a:ln>
                <a:solidFill>
                  <a:schemeClr val="tx1">
                    <a:lumMod val="65000"/>
                    <a:lumOff val="35000"/>
                  </a:schemeClr>
                </a:solidFill>
                <a:prstDash val="dash"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BBE8CDA5-67D7-35BE-EB6A-7710CD1578DF}"/>
                </a:ext>
              </a:extLst>
            </p:cNvPr>
            <p:cNvGrpSpPr/>
            <p:nvPr/>
          </p:nvGrpSpPr>
          <p:grpSpPr>
            <a:xfrm>
              <a:off x="7423745" y="3116782"/>
              <a:ext cx="892629" cy="1649193"/>
              <a:chOff x="7254059" y="3116782"/>
              <a:chExt cx="892629" cy="1649193"/>
            </a:xfrm>
          </p:grpSpPr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CC3AD4A6-433A-4015-0A62-C33752B5738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64303" y="3256184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D890B3C5-D9BB-BA4F-5C7B-E8736CA47CCC}"/>
                  </a:ext>
                </a:extLst>
              </p:cNvPr>
              <p:cNvSpPr txBox="1"/>
              <p:nvPr/>
            </p:nvSpPr>
            <p:spPr>
              <a:xfrm flipH="1">
                <a:off x="7409114" y="3116782"/>
                <a:ext cx="7375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5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43E3CDC9-F3D3-CD48-5BAB-0B1B91FFD84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56806" y="3366412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8E98FB9F-9E57-A8E8-B9FF-F2511091ECAB}"/>
                  </a:ext>
                </a:extLst>
              </p:cNvPr>
              <p:cNvSpPr txBox="1"/>
              <p:nvPr/>
            </p:nvSpPr>
            <p:spPr>
              <a:xfrm flipH="1">
                <a:off x="7405798" y="3226686"/>
                <a:ext cx="7375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3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11" name="Straight Connector 110">
                <a:extLst>
                  <a:ext uri="{FF2B5EF4-FFF2-40B4-BE49-F238E27FC236}">
                    <a16:creationId xmlns:a16="http://schemas.microsoft.com/office/drawing/2014/main" id="{CBAFA027-7963-2830-B2BC-774E70EED31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54059" y="3466960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43B4CE81-D371-5392-8A29-6307B0AB8131}"/>
                  </a:ext>
                </a:extLst>
              </p:cNvPr>
              <p:cNvSpPr txBox="1"/>
              <p:nvPr/>
            </p:nvSpPr>
            <p:spPr>
              <a:xfrm flipH="1">
                <a:off x="7401822" y="3350678"/>
                <a:ext cx="7375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0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13" name="Straight Connector 112">
                <a:extLst>
                  <a:ext uri="{FF2B5EF4-FFF2-40B4-BE49-F238E27FC236}">
                    <a16:creationId xmlns:a16="http://schemas.microsoft.com/office/drawing/2014/main" id="{BAE9F6C2-2AD1-910D-9DBA-9212985D5E9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59099" y="3569134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FBC4F0D5-9BB7-F11C-BB50-CDFD25B5BE66}"/>
                  </a:ext>
                </a:extLst>
              </p:cNvPr>
              <p:cNvSpPr txBox="1"/>
              <p:nvPr/>
            </p:nvSpPr>
            <p:spPr>
              <a:xfrm flipH="1">
                <a:off x="7417962" y="3452719"/>
                <a:ext cx="6558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70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15" name="Straight Connector 114">
                <a:extLst>
                  <a:ext uri="{FF2B5EF4-FFF2-40B4-BE49-F238E27FC236}">
                    <a16:creationId xmlns:a16="http://schemas.microsoft.com/office/drawing/2014/main" id="{480D647A-DE56-2FCA-3BDC-504C5EF1114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54504" y="3729359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TextBox 115">
                <a:extLst>
                  <a:ext uri="{FF2B5EF4-FFF2-40B4-BE49-F238E27FC236}">
                    <a16:creationId xmlns:a16="http://schemas.microsoft.com/office/drawing/2014/main" id="{4D00D091-6F74-91F7-191C-DD76EF4D51FC}"/>
                  </a:ext>
                </a:extLst>
              </p:cNvPr>
              <p:cNvSpPr txBox="1"/>
              <p:nvPr/>
            </p:nvSpPr>
            <p:spPr>
              <a:xfrm flipH="1">
                <a:off x="7411283" y="3621530"/>
                <a:ext cx="6558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5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17" name="Straight Connector 116">
                <a:extLst>
                  <a:ext uri="{FF2B5EF4-FFF2-40B4-BE49-F238E27FC236}">
                    <a16:creationId xmlns:a16="http://schemas.microsoft.com/office/drawing/2014/main" id="{12DFDBD4-BB05-7947-8235-CD29D374BFC6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66346" y="3994845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8" name="TextBox 117">
                <a:extLst>
                  <a:ext uri="{FF2B5EF4-FFF2-40B4-BE49-F238E27FC236}">
                    <a16:creationId xmlns:a16="http://schemas.microsoft.com/office/drawing/2014/main" id="{79EA3E58-A8C7-8CB2-945C-A9CF1B733B5D}"/>
                  </a:ext>
                </a:extLst>
              </p:cNvPr>
              <p:cNvSpPr txBox="1"/>
              <p:nvPr/>
            </p:nvSpPr>
            <p:spPr>
              <a:xfrm flipH="1">
                <a:off x="7399697" y="3842991"/>
                <a:ext cx="6558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3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id="{12901C0C-C479-E203-74A9-D2759562733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67083" y="4210692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AECBBD50-18B9-53CE-6CA0-04F074D04564}"/>
                  </a:ext>
                </a:extLst>
              </p:cNvPr>
              <p:cNvSpPr txBox="1"/>
              <p:nvPr/>
            </p:nvSpPr>
            <p:spPr>
              <a:xfrm flipH="1">
                <a:off x="7411185" y="4055518"/>
                <a:ext cx="6558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2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  <p:cxnSp>
            <p:nvCxnSpPr>
              <p:cNvPr id="125" name="Straight Connector 124">
                <a:extLst>
                  <a:ext uri="{FF2B5EF4-FFF2-40B4-BE49-F238E27FC236}">
                    <a16:creationId xmlns:a16="http://schemas.microsoft.com/office/drawing/2014/main" id="{3C07ED19-36B9-8B74-AA25-72B0A5D3E300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7276004" y="4640672"/>
                <a:ext cx="11989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618BEDB7-E7AF-BA7D-8AEB-E6CDCF229914}"/>
                  </a:ext>
                </a:extLst>
              </p:cNvPr>
              <p:cNvSpPr txBox="1"/>
              <p:nvPr/>
            </p:nvSpPr>
            <p:spPr>
              <a:xfrm flipH="1">
                <a:off x="7407347" y="4488976"/>
                <a:ext cx="65582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15 </a:t>
                </a:r>
                <a:r>
                  <a:rPr lang="en-US" sz="1200" dirty="0" err="1"/>
                  <a:t>KDa</a:t>
                </a:r>
                <a:endParaRPr lang="en-US" sz="1200" dirty="0"/>
              </a:p>
            </p:txBody>
          </p:sp>
        </p:grpSp>
      </p:grpSp>
      <p:sp>
        <p:nvSpPr>
          <p:cNvPr id="123" name="TextBox 122">
            <a:extLst>
              <a:ext uri="{FF2B5EF4-FFF2-40B4-BE49-F238E27FC236}">
                <a16:creationId xmlns:a16="http://schemas.microsoft.com/office/drawing/2014/main" id="{EFFEFE32-C32D-800C-A447-E26427223B92}"/>
              </a:ext>
            </a:extLst>
          </p:cNvPr>
          <p:cNvSpPr txBox="1"/>
          <p:nvPr/>
        </p:nvSpPr>
        <p:spPr>
          <a:xfrm>
            <a:off x="128000" y="50149"/>
            <a:ext cx="2816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aw data for Supp Figure 9</a:t>
            </a:r>
          </a:p>
        </p:txBody>
      </p:sp>
    </p:spTree>
    <p:extLst>
      <p:ext uri="{BB962C8B-B14F-4D97-AF65-F5344CB8AC3E}">
        <p14:creationId xmlns:p14="http://schemas.microsoft.com/office/powerpoint/2010/main" val="20468241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7</TotalTime>
  <Words>206</Words>
  <Application>Microsoft Office PowerPoint</Application>
  <PresentationFormat>Widescreen</PresentationFormat>
  <Paragraphs>15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>UAB Dept of Path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lhamamsy, Amr Rafat</dc:creator>
  <cp:lastModifiedBy>Amr Elhamamsy</cp:lastModifiedBy>
  <cp:revision>5</cp:revision>
  <dcterms:created xsi:type="dcterms:W3CDTF">2025-02-27T21:01:57Z</dcterms:created>
  <dcterms:modified xsi:type="dcterms:W3CDTF">2025-08-24T04:59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f03a1110-2b89-49af-85e6-708c040c3dce_Enabled">
    <vt:lpwstr>true</vt:lpwstr>
  </property>
  <property fmtid="{D5CDD505-2E9C-101B-9397-08002B2CF9AE}" pid="3" name="MSIP_Label_f03a1110-2b89-49af-85e6-708c040c3dce_SetDate">
    <vt:lpwstr>2025-02-27T22:59:54Z</vt:lpwstr>
  </property>
  <property fmtid="{D5CDD505-2E9C-101B-9397-08002B2CF9AE}" pid="4" name="MSIP_Label_f03a1110-2b89-49af-85e6-708c040c3dce_Method">
    <vt:lpwstr>Privileged</vt:lpwstr>
  </property>
  <property fmtid="{D5CDD505-2E9C-101B-9397-08002B2CF9AE}" pid="5" name="MSIP_Label_f03a1110-2b89-49af-85e6-708c040c3dce_Name">
    <vt:lpwstr>Public</vt:lpwstr>
  </property>
  <property fmtid="{D5CDD505-2E9C-101B-9397-08002B2CF9AE}" pid="6" name="MSIP_Label_f03a1110-2b89-49af-85e6-708c040c3dce_SiteId">
    <vt:lpwstr>d8999fe4-76af-40b3-b435-1d8977abc08c</vt:lpwstr>
  </property>
  <property fmtid="{D5CDD505-2E9C-101B-9397-08002B2CF9AE}" pid="7" name="MSIP_Label_f03a1110-2b89-49af-85e6-708c040c3dce_ActionId">
    <vt:lpwstr>920f9722-4817-49d8-8347-9e6ca84462dc</vt:lpwstr>
  </property>
  <property fmtid="{D5CDD505-2E9C-101B-9397-08002B2CF9AE}" pid="8" name="MSIP_Label_f03a1110-2b89-49af-85e6-708c040c3dce_ContentBits">
    <vt:lpwstr>0</vt:lpwstr>
  </property>
  <property fmtid="{D5CDD505-2E9C-101B-9397-08002B2CF9AE}" pid="9" name="MSIP_Label_f03a1110-2b89-49af-85e6-708c040c3dce_Tag">
    <vt:lpwstr>10, 0, 1, 1</vt:lpwstr>
  </property>
</Properties>
</file>